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1470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F:\Lizzie\Chapter%203%20Results\Aim%201%20Tumour%20growth%20Rate\Tumour%20Growth%20Rate\Lewis%20Lung%20Carcinoma\1x10%5e6\lewis%201x10%5e6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F:\Lizzie\Chapter%203%20Results\Aim%201%20Tumour%20growth%20Rate\Tumour%20Growth%20Rate\B16F10%20Melanoma\106\B16%201x10%5e6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Lewis%20Lung%20Carcinoma\1x10%5e6\lewis%201x10%5e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Lewis%20Lung%20Carcinoma\1x10%5e6\lewis%201x10%5e6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Lewis%20Lung%20Carcinoma\1x10%5e6\lewis%201x10%5e6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B16F10%20Melanoma\106\B16%201x10%5e6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B16F10%20Melanoma\106\B16%201x10%5e6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izzie\Results\Physiological%20asc%20study\Aim%201%20Tumour%20growth%20Rate\Tumour%20Growth%20Rate\B16F10%20Melanoma\106\B16%201x10%5e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4299040542314583E-2"/>
          <c:y val="0.1077426963225411"/>
          <c:w val="0.79800187034304892"/>
          <c:h val="0.76792264456704962"/>
        </c:manualLayout>
      </c:layout>
      <c:lineChart>
        <c:grouping val="standard"/>
        <c:varyColors val="0"/>
        <c:ser>
          <c:idx val="0"/>
          <c:order val="0"/>
          <c:tx>
            <c:v>3300mg/L</c:v>
          </c:tx>
          <c:spPr>
            <a:ln w="25400">
              <a:solidFill>
                <a:sysClr val="windowText" lastClr="000000">
                  <a:shade val="95000"/>
                  <a:satMod val="105000"/>
                </a:sys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Weight Change %'!$W$39,'Weight Change %'!$U$14,'Weight Change %'!$X$14,'Weight Change %'!$AA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0831317369937568</c:v>
                  </c:pt>
                  <c:pt idx="2">
                    <c:v>0.52064168841578395</c:v>
                  </c:pt>
                  <c:pt idx="3">
                    <c:v>0.71581091467664204</c:v>
                  </c:pt>
                </c:numCache>
              </c:numRef>
            </c:plus>
            <c:minus>
              <c:numRef>
                <c:f>('Weight Change %'!$W$39,'Weight Change %'!$U$14,'Weight Change %'!$X$14,'Weight Change %'!$AA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0831317369937568</c:v>
                  </c:pt>
                  <c:pt idx="2">
                    <c:v>0.52064168841578395</c:v>
                  </c:pt>
                  <c:pt idx="3">
                    <c:v>0.71581091467664204</c:v>
                  </c:pt>
                </c:numCache>
              </c:numRef>
            </c:minus>
          </c:errBars>
          <c:cat>
            <c:numRef>
              <c:f>('Weight Change %'!$W$39,'Weight Change %'!$V$42,'Weight Change %'!$W$42,'Weight Change %'!$X$42,'Weight Change %'!$Y$42)</c:f>
              <c:numCache>
                <c:formatCode>General</c:formatCode>
                <c:ptCount val="5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W$39,'Weight Change %'!$T$15,'Weight Change %'!$W$15,'Weight Change %'!$Z$15)</c:f>
              <c:numCache>
                <c:formatCode>General</c:formatCode>
                <c:ptCount val="4"/>
                <c:pt idx="0">
                  <c:v>0</c:v>
                </c:pt>
                <c:pt idx="1">
                  <c:v>2.253802002224857</c:v>
                </c:pt>
                <c:pt idx="2">
                  <c:v>2.6200372449729081</c:v>
                </c:pt>
                <c:pt idx="3">
                  <c:v>4.4901369889094562</c:v>
                </c:pt>
              </c:numCache>
            </c:numRef>
          </c:val>
          <c:smooth val="0"/>
        </c:ser>
        <c:ser>
          <c:idx val="1"/>
          <c:order val="1"/>
          <c:tx>
            <c:v>330mg/L</c:v>
          </c:tx>
          <c:spPr>
            <a:ln w="25400">
              <a:solidFill>
                <a:sysClr val="windowText" lastClr="000000">
                  <a:shade val="95000"/>
                  <a:satMod val="105000"/>
                </a:sysClr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Weight Change %'!$W$39,'Weight Change %'!$U$24,'Weight Change %'!$X$24,'Weight Change %'!$AA$2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88506464621595438</c:v>
                  </c:pt>
                  <c:pt idx="2">
                    <c:v>0.56430390179101586</c:v>
                  </c:pt>
                  <c:pt idx="3">
                    <c:v>0.76947099170408162</c:v>
                  </c:pt>
                </c:numCache>
              </c:numRef>
            </c:plus>
            <c:minus>
              <c:numRef>
                <c:f>('Weight Change %'!$W$39,'Weight Change %'!$U$24,'Weight Change %'!$X$24,'Weight Change %'!$AA$2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88506464621595438</c:v>
                  </c:pt>
                  <c:pt idx="2">
                    <c:v>0.56430390179101586</c:v>
                  </c:pt>
                  <c:pt idx="3">
                    <c:v>0.76947099170408162</c:v>
                  </c:pt>
                </c:numCache>
              </c:numRef>
            </c:minus>
          </c:errBars>
          <c:cat>
            <c:numRef>
              <c:f>('Weight Change %'!$W$39,'Weight Change %'!$V$42,'Weight Change %'!$W$42,'Weight Change %'!$X$42,'Weight Change %'!$Y$42)</c:f>
              <c:numCache>
                <c:formatCode>General</c:formatCode>
                <c:ptCount val="5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W$39,'Weight Change %'!$T$25,'Weight Change %'!$W$25,'Weight Change %'!$Z$25)</c:f>
              <c:numCache>
                <c:formatCode>General</c:formatCode>
                <c:ptCount val="4"/>
                <c:pt idx="0">
                  <c:v>0</c:v>
                </c:pt>
                <c:pt idx="1">
                  <c:v>0.28511867350049769</c:v>
                </c:pt>
                <c:pt idx="2">
                  <c:v>0.68577404176683932</c:v>
                </c:pt>
                <c:pt idx="3">
                  <c:v>5.4600593714464019</c:v>
                </c:pt>
              </c:numCache>
            </c:numRef>
          </c:val>
          <c:smooth val="0"/>
        </c:ser>
        <c:ser>
          <c:idx val="2"/>
          <c:order val="2"/>
          <c:tx>
            <c:v>33mg/L</c:v>
          </c:tx>
          <c:spPr>
            <a:ln w="25400">
              <a:solidFill>
                <a:sysClr val="windowText" lastClr="000000">
                  <a:shade val="95000"/>
                  <a:satMod val="105000"/>
                </a:sysClr>
              </a:solidFill>
              <a:prstDash val="sysDash"/>
            </a:ln>
          </c:spPr>
          <c:marker>
            <c:symbol val="none"/>
          </c:marker>
          <c:dPt>
            <c:idx val="2"/>
            <c:bubble3D val="0"/>
            <c:spPr>
              <a:ln w="25400">
                <a:solidFill>
                  <a:sysClr val="windowText" lastClr="000000">
                    <a:shade val="95000"/>
                    <a:satMod val="105000"/>
                  </a:sysClr>
                </a:solidFill>
                <a:prstDash val="dash"/>
              </a:ln>
            </c:spPr>
          </c:dPt>
          <c:errBars>
            <c:errDir val="y"/>
            <c:errBarType val="both"/>
            <c:errValType val="cust"/>
            <c:noEndCap val="0"/>
            <c:plus>
              <c:numRef>
                <c:f>('Weight Change %'!$W$39,'Weight Change %'!$U$34,'Weight Change %'!$X$34,'Weight Change %'!$AA$3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163353809896026</c:v>
                  </c:pt>
                  <c:pt idx="2">
                    <c:v>1.2472239717164251</c:v>
                  </c:pt>
                  <c:pt idx="3">
                    <c:v>0.78998499198614502</c:v>
                  </c:pt>
                </c:numCache>
              </c:numRef>
            </c:plus>
            <c:minus>
              <c:numRef>
                <c:f>('Weight Change %'!$W$39,'Weight Change %'!$U$34,'Weight Change %'!$X$34,'Weight Change %'!$AA$3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163353809896026</c:v>
                  </c:pt>
                  <c:pt idx="2">
                    <c:v>1.2472239717164251</c:v>
                  </c:pt>
                  <c:pt idx="3">
                    <c:v>0.78998499198614502</c:v>
                  </c:pt>
                </c:numCache>
              </c:numRef>
            </c:minus>
          </c:errBars>
          <c:cat>
            <c:numRef>
              <c:f>('Weight Change %'!$W$39,'Weight Change %'!$V$42,'Weight Change %'!$W$42,'Weight Change %'!$X$42,'Weight Change %'!$Y$42)</c:f>
              <c:numCache>
                <c:formatCode>General</c:formatCode>
                <c:ptCount val="5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W$39,'Weight Change %'!$T$35,'Weight Change %'!$W$35,'Weight Change %'!$Z$35,'Weight Change %'!$AC$36)</c:f>
              <c:numCache>
                <c:formatCode>General</c:formatCode>
                <c:ptCount val="5"/>
                <c:pt idx="0">
                  <c:v>0</c:v>
                </c:pt>
                <c:pt idx="1">
                  <c:v>-1.7582609641252911</c:v>
                </c:pt>
                <c:pt idx="2">
                  <c:v>-6.1761965687116893</c:v>
                </c:pt>
                <c:pt idx="3">
                  <c:v>-9.259469225850056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5013888"/>
        <c:axId val="155022080"/>
      </c:lineChart>
      <c:dateAx>
        <c:axId val="1550138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5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NZ" sz="1000">
                    <a:latin typeface="Arial" panose="020B0604020202020204" pitchFamily="34" charset="0"/>
                    <a:cs typeface="Arial" panose="020B0604020202020204" pitchFamily="34" charset="0"/>
                  </a:rPr>
                  <a:t>Time</a:t>
                </a:r>
                <a:r>
                  <a:rPr lang="en-NZ" sz="10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ince tumour initiation (days)</a:t>
                </a:r>
                <a:endParaRPr lang="en-NZ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in"/>
        <c:minorTickMark val="in"/>
        <c:tickLblPos val="nextTo"/>
        <c:txPr>
          <a:bodyPr/>
          <a:lstStyle/>
          <a:p>
            <a:pPr>
              <a:defRPr sz="1050" b="0"/>
            </a:pPr>
            <a:endParaRPr lang="en-US"/>
          </a:p>
        </c:txPr>
        <c:crossAx val="155022080"/>
        <c:crosses val="autoZero"/>
        <c:auto val="0"/>
        <c:lblOffset val="100"/>
        <c:baseTimeUnit val="days"/>
        <c:majorUnit val="4"/>
        <c:majorTimeUnit val="days"/>
      </c:dateAx>
      <c:valAx>
        <c:axId val="15502208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in"/>
        <c:tickLblPos val="nextTo"/>
        <c:txPr>
          <a:bodyPr/>
          <a:lstStyle/>
          <a:p>
            <a:pPr>
              <a:defRPr sz="10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55013888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11020173607621918"/>
          <c:y val="0.63332279002666925"/>
          <c:w val="0.3111803678000436"/>
          <c:h val="0.2163375612375521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437449587235962"/>
          <c:y val="5.1490689081718569E-2"/>
          <c:w val="0.8357041104471844"/>
          <c:h val="0.81414943236437876"/>
        </c:manualLayout>
      </c:layout>
      <c:lineChart>
        <c:grouping val="standard"/>
        <c:varyColors val="0"/>
        <c:ser>
          <c:idx val="0"/>
          <c:order val="0"/>
          <c:tx>
            <c:v>optimal</c:v>
          </c:tx>
          <c:spPr>
            <a:ln w="25400">
              <a:solidFill>
                <a:sysClr val="windowText" lastClr="0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Weight Change %'!$H$39,'Weight Change %'!$U$14,'Weight Change %'!$X$14,'Weight Change %'!$AA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7931463616867365</c:v>
                  </c:pt>
                  <c:pt idx="2">
                    <c:v>0.54918611445994825</c:v>
                  </c:pt>
                  <c:pt idx="3">
                    <c:v>0.75860430750187058</c:v>
                  </c:pt>
                </c:numCache>
              </c:numRef>
            </c:plus>
            <c:minus>
              <c:numRef>
                <c:f>('Weight Change %'!$H$39,'Weight Change %'!$U$14,'Weight Change %'!$X$14,'Weight Change %'!$AA$1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7931463616867365</c:v>
                  </c:pt>
                  <c:pt idx="2">
                    <c:v>0.54918611445994825</c:v>
                  </c:pt>
                  <c:pt idx="3">
                    <c:v>0.75860430750187058</c:v>
                  </c:pt>
                </c:numCache>
              </c:numRef>
            </c:minus>
          </c:errBars>
          <c:cat>
            <c:numRef>
              <c:f>'Weight Change %'!$H$39:$K$39</c:f>
              <c:numCache>
                <c:formatCode>General</c:formatCode>
                <c:ptCount val="4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V$10,'Weight Change %'!$T$15,'Weight Change %'!$W$15,'Weight Change %'!$Z$15)</c:f>
              <c:numCache>
                <c:formatCode>General</c:formatCode>
                <c:ptCount val="4"/>
                <c:pt idx="0">
                  <c:v>0</c:v>
                </c:pt>
                <c:pt idx="1">
                  <c:v>1.8184791300645646</c:v>
                </c:pt>
                <c:pt idx="2">
                  <c:v>2.9608324192275504</c:v>
                </c:pt>
                <c:pt idx="3">
                  <c:v>4.6771539145781516</c:v>
                </c:pt>
              </c:numCache>
            </c:numRef>
          </c:val>
          <c:smooth val="0"/>
        </c:ser>
        <c:ser>
          <c:idx val="1"/>
          <c:order val="1"/>
          <c:tx>
            <c:v>Medium</c:v>
          </c:tx>
          <c:spPr>
            <a:ln w="25400">
              <a:solidFill>
                <a:sysClr val="windowText" lastClr="0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Weight Change %'!$H$39,'Weight Change %'!$U$24,'Weight Change %'!$X$24,'Weight Change %'!$AA$2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2161300777741129</c:v>
                  </c:pt>
                  <c:pt idx="2">
                    <c:v>1.335113810448032</c:v>
                  </c:pt>
                  <c:pt idx="3">
                    <c:v>1.5328164627527938</c:v>
                  </c:pt>
                </c:numCache>
              </c:numRef>
            </c:plus>
            <c:minus>
              <c:numRef>
                <c:f>('Weight Change %'!$H$39,'Weight Change %'!$U$24,'Weight Change %'!$X$24,'Weight Change %'!$AA$2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92161300777741129</c:v>
                  </c:pt>
                  <c:pt idx="2">
                    <c:v>1.335113810448032</c:v>
                  </c:pt>
                  <c:pt idx="3">
                    <c:v>1.5328164627527938</c:v>
                  </c:pt>
                </c:numCache>
              </c:numRef>
            </c:minus>
          </c:errBars>
          <c:cat>
            <c:numRef>
              <c:f>'Weight Change %'!$H$39:$K$39</c:f>
              <c:numCache>
                <c:formatCode>General</c:formatCode>
                <c:ptCount val="4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V$10,'Weight Change %'!$T$25,'Weight Change %'!$W$25,'Weight Change %'!$Z$25)</c:f>
              <c:numCache>
                <c:formatCode>General</c:formatCode>
                <c:ptCount val="4"/>
                <c:pt idx="0">
                  <c:v>0</c:v>
                </c:pt>
                <c:pt idx="1">
                  <c:v>0.10840907226639032</c:v>
                </c:pt>
                <c:pt idx="2">
                  <c:v>2.137696087623131</c:v>
                </c:pt>
                <c:pt idx="3">
                  <c:v>5.3152761967762618</c:v>
                </c:pt>
              </c:numCache>
            </c:numRef>
          </c:val>
          <c:smooth val="0"/>
        </c:ser>
        <c:ser>
          <c:idx val="2"/>
          <c:order val="2"/>
          <c:tx>
            <c:v>Low</c:v>
          </c:tx>
          <c:spPr>
            <a:ln w="25400">
              <a:solidFill>
                <a:sysClr val="windowText" lastClr="000000"/>
              </a:solidFill>
              <a:prstDash val="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('Weight Change %'!$H$39,'Weight Change %'!$U$34,'Weight Change %'!$X$34,'Weight Change %'!$AA$3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61770575758557378</c:v>
                  </c:pt>
                  <c:pt idx="2">
                    <c:v>1.0512801927860458</c:v>
                  </c:pt>
                  <c:pt idx="3">
                    <c:v>1.1250323562308351</c:v>
                  </c:pt>
                </c:numCache>
              </c:numRef>
            </c:plus>
            <c:minus>
              <c:numRef>
                <c:f>('Weight Change %'!$A$40,'Weight Change %'!$U$34,'Weight Change %'!$X$34,'Weight Change %'!$AA$34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61770575758557378</c:v>
                  </c:pt>
                  <c:pt idx="2">
                    <c:v>1.0512801927860458</c:v>
                  </c:pt>
                  <c:pt idx="3">
                    <c:v>1.1250323562308351</c:v>
                  </c:pt>
                </c:numCache>
              </c:numRef>
            </c:minus>
          </c:errBars>
          <c:cat>
            <c:numRef>
              <c:f>'Weight Change %'!$H$39:$K$39</c:f>
              <c:numCache>
                <c:formatCode>General</c:formatCode>
                <c:ptCount val="4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</c:numCache>
            </c:numRef>
          </c:cat>
          <c:val>
            <c:numRef>
              <c:f>('Weight Change %'!$V$10,'Weight Change %'!$T$35,'Weight Change %'!$W$35,'Weight Change %'!$Z$35)</c:f>
              <c:numCache>
                <c:formatCode>General</c:formatCode>
                <c:ptCount val="4"/>
                <c:pt idx="0">
                  <c:v>0</c:v>
                </c:pt>
                <c:pt idx="1">
                  <c:v>-4.0106830622820553</c:v>
                </c:pt>
                <c:pt idx="2">
                  <c:v>-2.4072441499754458</c:v>
                </c:pt>
                <c:pt idx="3">
                  <c:v>-1.688313100889744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5728896"/>
        <c:axId val="155743360"/>
      </c:lineChart>
      <c:dateAx>
        <c:axId val="1557288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NZ">
                    <a:latin typeface="Arial" panose="020B0604020202020204" pitchFamily="34" charset="0"/>
                    <a:cs typeface="Arial" panose="020B0604020202020204" pitchFamily="34" charset="0"/>
                  </a:rPr>
                  <a:t>Time</a:t>
                </a:r>
                <a:r>
                  <a:rPr lang="en-NZ" baseline="0">
                    <a:latin typeface="Arial" panose="020B0604020202020204" pitchFamily="34" charset="0"/>
                    <a:cs typeface="Arial" panose="020B0604020202020204" pitchFamily="34" charset="0"/>
                  </a:rPr>
                  <a:t> since tumour initiation (days)</a:t>
                </a:r>
                <a:endParaRPr lang="en-NZ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in"/>
        <c:tickLblPos val="nextTo"/>
        <c:txPr>
          <a:bodyPr rot="0" vert="horz" anchor="t" anchorCtr="1"/>
          <a:lstStyle/>
          <a:p>
            <a:pPr>
              <a:defRPr/>
            </a:pPr>
            <a:endParaRPr lang="en-US"/>
          </a:p>
        </c:txPr>
        <c:crossAx val="155743360"/>
        <c:crosses val="autoZero"/>
        <c:auto val="0"/>
        <c:lblOffset val="100"/>
        <c:baseTimeUnit val="days"/>
        <c:majorUnit val="5"/>
        <c:majorTimeUnit val="days"/>
      </c:dateAx>
      <c:valAx>
        <c:axId val="155743360"/>
        <c:scaling>
          <c:orientation val="minMax"/>
          <c:min val="-12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05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NZ" sz="1050" b="0">
                    <a:latin typeface="Arial" panose="020B0604020202020204" pitchFamily="34" charset="0"/>
                    <a:cs typeface="Arial" panose="020B0604020202020204" pitchFamily="34" charset="0"/>
                  </a:rPr>
                  <a:t>% body weight change</a:t>
                </a:r>
              </a:p>
            </c:rich>
          </c:tx>
          <c:layout>
            <c:manualLayout>
              <c:xMode val="edge"/>
              <c:yMode val="edge"/>
              <c:x val="1.2813707913973368E-2"/>
              <c:y val="0.1551730749281621"/>
            </c:manualLayout>
          </c:layout>
          <c:overlay val="0"/>
        </c:title>
        <c:numFmt formatCode="@" sourceLinked="0"/>
        <c:majorTickMark val="none"/>
        <c:minorTickMark val="in"/>
        <c:tickLblPos val="nextTo"/>
        <c:txPr>
          <a:bodyPr/>
          <a:lstStyle/>
          <a:p>
            <a:pPr>
              <a:defRPr sz="10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557288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88725773173471"/>
          <c:y val="3.509212009798373E-2"/>
          <c:w val="0.78310270766342549"/>
          <c:h val="0.76646032639279671"/>
        </c:manualLayout>
      </c:layout>
      <c:lineChart>
        <c:grouping val="standard"/>
        <c:varyColors val="0"/>
        <c:ser>
          <c:idx val="0"/>
          <c:order val="0"/>
          <c:tx>
            <c:v>19.2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58,'Tumour Growth'!$H$8,'Tumour Growth'!$L$8,'Tumour Growth'!$P$8,'Tumour Growth'!$T$8,'Tumour Growth'!$X$8,'Tumour Growth'!$AB$8,'Tumour Growth'!$AF$8,'Tumour Growth'!$AJ$8,'Tumour Growth'!$AN$8,'Tumour Growth'!$AR$8,'Tumour Growth'!$AV$8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41.887900000000002</c:v>
                </c:pt>
                <c:pt idx="3">
                  <c:v>78.524999999999991</c:v>
                </c:pt>
                <c:pt idx="4" formatCode="General">
                  <c:v>75.384</c:v>
                </c:pt>
                <c:pt idx="5" formatCode="General">
                  <c:v>169.61399999999998</c:v>
                </c:pt>
                <c:pt idx="6" formatCode="General">
                  <c:v>169.61399999999998</c:v>
                </c:pt>
                <c:pt idx="7" formatCode="General">
                  <c:v>230.86349999999999</c:v>
                </c:pt>
                <c:pt idx="8" formatCode="General">
                  <c:v>282.16649999999998</c:v>
                </c:pt>
                <c:pt idx="9" formatCode="General">
                  <c:v>282.16649999999998</c:v>
                </c:pt>
                <c:pt idx="10" formatCode="General">
                  <c:v>402.048</c:v>
                </c:pt>
                <c:pt idx="11" formatCode="General">
                  <c:v>979.99199999999996</c:v>
                </c:pt>
              </c:numCache>
            </c:numRef>
          </c:val>
          <c:smooth val="0"/>
        </c:ser>
        <c:ser>
          <c:idx val="1"/>
          <c:order val="1"/>
          <c:tx>
            <c:v>19.3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58,'Tumour Growth'!$H$9,'Tumour Growth'!$L$9,'Tumour Growth'!$P$9,'Tumour Growth'!$T$9,'Tumour Growth'!$X$9,'Tumour Growth'!$AB$9,'Tumour Growth'!$AF$9,'Tumour Growth'!$AJ$9,'Tumour Growth'!$AN$9,'Tumour Growth'!$AR$9,'Tumour Growth'!$AV$9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33.510321600000005</c:v>
                </c:pt>
                <c:pt idx="2">
                  <c:v>78.539812499999996</c:v>
                </c:pt>
                <c:pt idx="3">
                  <c:v>50.256</c:v>
                </c:pt>
                <c:pt idx="4" formatCode="General">
                  <c:v>117.78749999999999</c:v>
                </c:pt>
                <c:pt idx="5" formatCode="General">
                  <c:v>117.78749999999999</c:v>
                </c:pt>
                <c:pt idx="6" formatCode="General">
                  <c:v>256.51499999999999</c:v>
                </c:pt>
                <c:pt idx="7" formatCode="General">
                  <c:v>256.51499999999999</c:v>
                </c:pt>
                <c:pt idx="8" formatCode="General">
                  <c:v>282.16649999999998</c:v>
                </c:pt>
                <c:pt idx="9" formatCode="General">
                  <c:v>335.03999999999996</c:v>
                </c:pt>
                <c:pt idx="10" formatCode="General">
                  <c:v>979.99199999999996</c:v>
                </c:pt>
              </c:numCache>
            </c:numRef>
          </c:val>
          <c:smooth val="0"/>
        </c:ser>
        <c:ser>
          <c:idx val="2"/>
          <c:order val="2"/>
          <c:tx>
            <c:v>19.4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58,'Tumour Growth'!$H$10,'Tumour Growth'!$L$10,'Tumour Growth'!$P$10,'Tumour Growth'!$T$10,'Tumour Growth'!$X$10,'Tumour Growth'!$AB$10,'Tumour Growth'!$AF$10,'Tumour Growth'!$AJ$10,'Tumour Growth'!$AN$10,'Tumour Growth'!$AR$10,'Tumour Growth'!$AV$10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.1887902000000006</c:v>
                </c:pt>
                <c:pt idx="2">
                  <c:v>33.51032</c:v>
                </c:pt>
                <c:pt idx="3">
                  <c:v>33.503999999999998</c:v>
                </c:pt>
                <c:pt idx="4" formatCode="General">
                  <c:v>33.503999999999998</c:v>
                </c:pt>
                <c:pt idx="5" formatCode="General">
                  <c:v>33.503999999999998</c:v>
                </c:pt>
                <c:pt idx="6" formatCode="General">
                  <c:v>33.503999999999998</c:v>
                </c:pt>
                <c:pt idx="7" formatCode="General">
                  <c:v>41.879999999999995</c:v>
                </c:pt>
                <c:pt idx="8" formatCode="General">
                  <c:v>205.21199999999999</c:v>
                </c:pt>
                <c:pt idx="9" formatCode="General">
                  <c:v>268.03199999999998</c:v>
                </c:pt>
                <c:pt idx="10" formatCode="General">
                  <c:v>523.5</c:v>
                </c:pt>
                <c:pt idx="11" formatCode="General">
                  <c:v>904.60799999999995</c:v>
                </c:pt>
              </c:numCache>
            </c:numRef>
          </c:val>
          <c:smooth val="0"/>
        </c:ser>
        <c:ser>
          <c:idx val="3"/>
          <c:order val="3"/>
          <c:tx>
            <c:v>19.5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58,'Tumour Growth'!$H$11,'Tumour Growth'!$L$11,'Tumour Growth'!$P$11,'Tumour Growth'!$T$11,'Tumour Growth'!$X$11,'Tumour Growth'!$AB$11,'Tumour Growth'!$AF$11,'Tumour Growth'!$AJ$11,'Tumour Growth'!$AN$11,'Tumour Growth'!$AR$11,'Tumour Growth'!$AV$11,'Tumour Growth'!$AZ$11)</c:f>
              <c:numCache>
                <c:formatCode>0.00</c:formatCode>
                <c:ptCount val="13"/>
                <c:pt idx="0" formatCode="General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 formatCode="General">
                  <c:v>0</c:v>
                </c:pt>
                <c:pt idx="5" formatCode="General">
                  <c:v>0</c:v>
                </c:pt>
                <c:pt idx="6" formatCode="General">
                  <c:v>207.30599999999998</c:v>
                </c:pt>
                <c:pt idx="7" formatCode="General">
                  <c:v>282.16649999999998</c:v>
                </c:pt>
                <c:pt idx="8" formatCode="General">
                  <c:v>207.30599999999998</c:v>
                </c:pt>
                <c:pt idx="9" formatCode="General">
                  <c:v>226.15199999999999</c:v>
                </c:pt>
                <c:pt idx="10" formatCode="General">
                  <c:v>551.24549999999999</c:v>
                </c:pt>
                <c:pt idx="11" formatCode="General">
                  <c:v>886.80899999999997</c:v>
                </c:pt>
                <c:pt idx="12" formatCode="General">
                  <c:v>1130.76</c:v>
                </c:pt>
              </c:numCache>
            </c:numRef>
          </c:val>
          <c:smooth val="0"/>
        </c:ser>
        <c:ser>
          <c:idx val="9"/>
          <c:order val="4"/>
          <c:tx>
            <c:v>19.6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G$16,'Tumour Growth'!$H$12,'Tumour Growth'!$L$12,'Tumour Growth'!$P$12,'Tumour Growth'!$T$12,'Tumour Growth'!$X$12,'Tumour Growth'!$AB$12,'Tumour Growth'!$AF$12,'Tumour Growth'!$AJ$12,'Tumour Growth'!$AN$12,'Tumour Growth'!$AR$12,'Tumour Growth'!$AV$12,'Tumour Growth'!$AZ$12)</c:f>
              <c:numCache>
                <c:formatCode>0.00</c:formatCode>
                <c:ptCount val="13"/>
                <c:pt idx="0" formatCode="General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4.134499999999999</c:v>
                </c:pt>
                <c:pt idx="4" formatCode="General">
                  <c:v>0</c:v>
                </c:pt>
                <c:pt idx="5" formatCode="General">
                  <c:v>14.134499999999999</c:v>
                </c:pt>
                <c:pt idx="6" formatCode="General">
                  <c:v>33.503999999999998</c:v>
                </c:pt>
                <c:pt idx="7" formatCode="General">
                  <c:v>41.879999999999995</c:v>
                </c:pt>
                <c:pt idx="8" formatCode="General">
                  <c:v>91.612499999999997</c:v>
                </c:pt>
                <c:pt idx="9" formatCode="General">
                  <c:v>169.61399999999998</c:v>
                </c:pt>
                <c:pt idx="10" formatCode="General">
                  <c:v>307.81799999999998</c:v>
                </c:pt>
                <c:pt idx="11" formatCode="General">
                  <c:v>680.55</c:v>
                </c:pt>
                <c:pt idx="12" formatCode="General">
                  <c:v>1013.496</c:v>
                </c:pt>
              </c:numCache>
            </c:numRef>
          </c:val>
          <c:smooth val="0"/>
        </c:ser>
        <c:ser>
          <c:idx val="4"/>
          <c:order val="5"/>
          <c:tx>
            <c:v>27.29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7,'Tumour Growth'!$H$13,'Tumour Growth'!$L$13,'Tumour Growth'!$P$13,'Tumour Growth'!$T$13,'Tumour Growth'!$X$13,'Tumour Growth'!$AB$13,'Tumour Growth'!$AF$13,'Tumour Growth'!$AJ$13,'Tumour Growth'!$AN$13,'Tumour Growth'!$AR$13,'Tumour Growth'!$AV$13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1.887902000000004</c:v>
                </c:pt>
                <c:pt idx="2">
                  <c:v>41.887900000000002</c:v>
                </c:pt>
                <c:pt idx="3">
                  <c:v>41.879999999999995</c:v>
                </c:pt>
                <c:pt idx="4" formatCode="General">
                  <c:v>91.612499999999997</c:v>
                </c:pt>
                <c:pt idx="5" formatCode="General">
                  <c:v>188.45999999999998</c:v>
                </c:pt>
                <c:pt idx="6" formatCode="General">
                  <c:v>207.30599999999998</c:v>
                </c:pt>
                <c:pt idx="7" formatCode="General">
                  <c:v>282.16649999999998</c:v>
                </c:pt>
                <c:pt idx="8" formatCode="General">
                  <c:v>466.43849999999998</c:v>
                </c:pt>
                <c:pt idx="9" formatCode="General">
                  <c:v>904.60799999999995</c:v>
                </c:pt>
                <c:pt idx="10" formatCode="General">
                  <c:v>1238.6009999999999</c:v>
                </c:pt>
              </c:numCache>
            </c:numRef>
          </c:val>
          <c:smooth val="0"/>
        </c:ser>
        <c:ser>
          <c:idx val="8"/>
          <c:order val="6"/>
          <c:tx>
            <c:v>27.4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7,'Tumour Growth'!$H$14,'Tumour Growth'!$L$14,'Tumour Growth'!$P$14,'Tumour Growth'!$T$14,'Tumour Growth'!$X$14,'Tumour Growth'!$AB$14,'Tumour Growth'!$AF$14,'Tumour Growth'!$AJ$14,'Tumour Growth'!$AN$14,'Tumour Growth'!$AR$14,'Tumour Growth'!$AV$14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.1887902000000006</c:v>
                </c:pt>
                <c:pt idx="2">
                  <c:v>12.566369999999999</c:v>
                </c:pt>
                <c:pt idx="3">
                  <c:v>50.256</c:v>
                </c:pt>
                <c:pt idx="4" formatCode="General">
                  <c:v>83.759999999999991</c:v>
                </c:pt>
                <c:pt idx="5" formatCode="General">
                  <c:v>207.30599999999998</c:v>
                </c:pt>
                <c:pt idx="6" formatCode="General">
                  <c:v>207.30599999999998</c:v>
                </c:pt>
                <c:pt idx="7" formatCode="General">
                  <c:v>307.81799999999998</c:v>
                </c:pt>
                <c:pt idx="8" formatCode="General">
                  <c:v>333.46949999999998</c:v>
                </c:pt>
                <c:pt idx="9" formatCode="General">
                  <c:v>551.24549999999999</c:v>
                </c:pt>
                <c:pt idx="10" formatCode="General">
                  <c:v>1436.4839999999999</c:v>
                </c:pt>
              </c:numCache>
            </c:numRef>
          </c:val>
          <c:smooth val="0"/>
        </c:ser>
        <c:ser>
          <c:idx val="5"/>
          <c:order val="7"/>
          <c:tx>
            <c:v>27.4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7,'Tumour Growth'!$H$15,'Tumour Growth'!$L$15,'Tumour Growth'!$P$15,'Tumour Growth'!$T$15,'Tumour Growth'!$X$15,'Tumour Growth'!$AB$15,'Tumour Growth'!$AF$15,'Tumour Growth'!$AJ$15,'Tumour Growth'!$AN$15,'Tumour Growth'!$AR$15,'Tumour Growth'!$AV$15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18.849555900000002</c:v>
                </c:pt>
                <c:pt idx="2">
                  <c:v>18.849554999999999</c:v>
                </c:pt>
                <c:pt idx="3">
                  <c:v>33.503999999999998</c:v>
                </c:pt>
                <c:pt idx="4" formatCode="General">
                  <c:v>41.879999999999995</c:v>
                </c:pt>
                <c:pt idx="5" formatCode="General">
                  <c:v>41.879999999999995</c:v>
                </c:pt>
                <c:pt idx="6" formatCode="General">
                  <c:v>113.07599999999999</c:v>
                </c:pt>
                <c:pt idx="7" formatCode="General">
                  <c:v>153.90899999999999</c:v>
                </c:pt>
                <c:pt idx="8" formatCode="General">
                  <c:v>256.51499999999999</c:v>
                </c:pt>
                <c:pt idx="9" formatCode="General">
                  <c:v>335.03999999999996</c:v>
                </c:pt>
                <c:pt idx="10" formatCode="General">
                  <c:v>760.12199999999996</c:v>
                </c:pt>
                <c:pt idx="11" formatCode="General">
                  <c:v>979.99199999999996</c:v>
                </c:pt>
              </c:numCache>
            </c:numRef>
          </c:val>
          <c:smooth val="0"/>
        </c:ser>
        <c:ser>
          <c:idx val="6"/>
          <c:order val="8"/>
          <c:tx>
            <c:v>27.42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6,'Tumour Growth'!$H$16,'Tumour Growth'!$L$16,'Tumour Growth'!$P$16,'Tumour Growth'!$T$16,'Tumour Growth'!$X$16,'Tumour Growth'!$AB$16,'Tumour Growth'!$AF$16,'Tumour Growth'!$AJ$16,'Tumour Growth'!$AN$16,'Tumour Growth'!$AR$16,'Tumour Growth'!$AV$16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4.18879</c:v>
                </c:pt>
                <c:pt idx="3">
                  <c:v>47.114999999999995</c:v>
                </c:pt>
                <c:pt idx="4" formatCode="General">
                  <c:v>83.759999999999991</c:v>
                </c:pt>
                <c:pt idx="5" formatCode="General">
                  <c:v>100.512</c:v>
                </c:pt>
                <c:pt idx="6" formatCode="General">
                  <c:v>143.96249999999998</c:v>
                </c:pt>
                <c:pt idx="7" formatCode="General">
                  <c:v>143.96249999999998</c:v>
                </c:pt>
                <c:pt idx="8" formatCode="General">
                  <c:v>157.04999999999998</c:v>
                </c:pt>
                <c:pt idx="9" formatCode="General">
                  <c:v>226.15199999999999</c:v>
                </c:pt>
                <c:pt idx="10" formatCode="General">
                  <c:v>551.24549999999999</c:v>
                </c:pt>
                <c:pt idx="11" formatCode="General">
                  <c:v>1150.1295</c:v>
                </c:pt>
              </c:numCache>
            </c:numRef>
          </c:val>
          <c:smooth val="0"/>
        </c:ser>
        <c:ser>
          <c:idx val="7"/>
          <c:order val="9"/>
          <c:tx>
            <c:v>27.43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7,'Tumour Growth'!$H$17,'Tumour Growth'!$L$17,'Tumour Growth'!$P$17,'Tumour Growth'!$T$17,'Tumour Growth'!$X$17,'Tumour Growth'!$AB$17,'Tumour Growth'!$AF$17,'Tumour Growth'!$AJ$17,'Tumour Growth'!$AN$17,'Tumour Growth'!$AR$17,'Tumour Growth'!$AV$17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23.561943750000001</c:v>
                </c:pt>
                <c:pt idx="3">
                  <c:v>41.879999999999995</c:v>
                </c:pt>
                <c:pt idx="4" formatCode="General">
                  <c:v>83.759999999999991</c:v>
                </c:pt>
                <c:pt idx="5" formatCode="General">
                  <c:v>130.875</c:v>
                </c:pt>
                <c:pt idx="6" formatCode="General">
                  <c:v>188.45999999999998</c:v>
                </c:pt>
                <c:pt idx="7" formatCode="General">
                  <c:v>282.16649999999998</c:v>
                </c:pt>
                <c:pt idx="8" formatCode="General">
                  <c:v>575.84999999999991</c:v>
                </c:pt>
                <c:pt idx="9" formatCode="General">
                  <c:v>823.46549999999991</c:v>
                </c:pt>
                <c:pt idx="10" formatCode="General">
                  <c:v>1055.37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305920"/>
        <c:axId val="164324096"/>
      </c:lineChart>
      <c:dateAx>
        <c:axId val="164305920"/>
        <c:scaling>
          <c:orientation val="minMax"/>
          <c:max val="28"/>
        </c:scaling>
        <c:delete val="0"/>
        <c:axPos val="b"/>
        <c:numFmt formatCode="General" sourceLinked="1"/>
        <c:majorTickMark val="out"/>
        <c:minorTickMark val="none"/>
        <c:tickLblPos val="nextTo"/>
        <c:crossAx val="164324096"/>
        <c:crosses val="autoZero"/>
        <c:auto val="0"/>
        <c:lblOffset val="100"/>
        <c:baseTimeUnit val="days"/>
        <c:majorUnit val="4"/>
        <c:majorTimeUnit val="days"/>
      </c:dateAx>
      <c:valAx>
        <c:axId val="164324096"/>
        <c:scaling>
          <c:orientation val="minMax"/>
          <c:max val="140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16430592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83569427031902"/>
          <c:y val="4.6923910033121755E-2"/>
          <c:w val="0.78805090848441239"/>
          <c:h val="0.7924755587716793"/>
        </c:manualLayout>
      </c:layout>
      <c:lineChart>
        <c:grouping val="standard"/>
        <c:varyColors val="0"/>
        <c:ser>
          <c:idx val="0"/>
          <c:order val="0"/>
          <c:tx>
            <c:v>11.86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18,'Tumour Growth'!$H$18,'Tumour Growth'!$L$18,'Tumour Growth'!$P$18,'Tumour Growth'!$T$18,'Tumour Growth'!$X$18,'Tumour Growth'!$AB$18,'Tumour Growth'!$AF$18,'Tumour Growth'!$AJ$18,'Tumour Growth'!$AN$18,'Tumour Growth'!$AR$18,'Tumour Growth'!$AV$18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4.18879</c:v>
                </c:pt>
                <c:pt idx="3">
                  <c:v>83.759999999999991</c:v>
                </c:pt>
                <c:pt idx="4" formatCode="General">
                  <c:v>75.384</c:v>
                </c:pt>
                <c:pt idx="5" formatCode="General">
                  <c:v>143.96249999999998</c:v>
                </c:pt>
                <c:pt idx="6" formatCode="General">
                  <c:v>157.04999999999998</c:v>
                </c:pt>
                <c:pt idx="7" formatCode="General">
                  <c:v>226.15199999999999</c:v>
                </c:pt>
                <c:pt idx="8" formatCode="General">
                  <c:v>628.19999999999993</c:v>
                </c:pt>
                <c:pt idx="9" formatCode="General">
                  <c:v>760.12199999999996</c:v>
                </c:pt>
                <c:pt idx="10" formatCode="General">
                  <c:v>1130.76</c:v>
                </c:pt>
              </c:numCache>
            </c:numRef>
          </c:val>
          <c:smooth val="0"/>
        </c:ser>
        <c:ser>
          <c:idx val="1"/>
          <c:order val="1"/>
          <c:tx>
            <c:v>11.87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0,'Tumour Growth'!$H$19,'Tumour Growth'!$L$19,'Tumour Growth'!$P$19,'Tumour Growth'!$T$19,'Tumour Growth'!$X$19,'Tumour Growth'!$AB$19,'Tumour Growth'!$AF$19,'Tumour Growth'!$AJ$19,'Tumour Growth'!$AN$19,'Tumour Growth'!$AR$19,'Tumour Growth'!$AV$19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.1887902000000006</c:v>
                </c:pt>
                <c:pt idx="2">
                  <c:v>41.887900000000002</c:v>
                </c:pt>
                <c:pt idx="3">
                  <c:v>41.879999999999995</c:v>
                </c:pt>
                <c:pt idx="4" formatCode="General">
                  <c:v>65.4375</c:v>
                </c:pt>
                <c:pt idx="5" formatCode="General">
                  <c:v>301.536</c:v>
                </c:pt>
                <c:pt idx="6" formatCode="General">
                  <c:v>551.24549999999999</c:v>
                </c:pt>
                <c:pt idx="7" formatCode="General">
                  <c:v>732.9</c:v>
                </c:pt>
                <c:pt idx="8" formatCode="General">
                  <c:v>823.46549999999991</c:v>
                </c:pt>
                <c:pt idx="9" formatCode="General">
                  <c:v>1130.76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2"/>
          <c:order val="2"/>
          <c:tx>
            <c:v>20.7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0,'Tumour Growth'!$H$20,'Tumour Growth'!$L$20,'Tumour Growth'!$P$20,'Tumour Growth'!$T$20,'Tumour Growth'!$X$20,'Tumour Growth'!$AB$20,'Tumour Growth'!$AF$20,'Tumour Growth'!$AJ$20,'Tumour Growth'!$AN$20,'Tumour Growth'!$AR$20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0</c:v>
                </c:pt>
                <c:pt idx="2">
                  <c:v>65.449843749999999</c:v>
                </c:pt>
                <c:pt idx="3">
                  <c:v>83.759999999999991</c:v>
                </c:pt>
                <c:pt idx="4" formatCode="General">
                  <c:v>83.759999999999991</c:v>
                </c:pt>
                <c:pt idx="5" formatCode="General">
                  <c:v>188.45999999999998</c:v>
                </c:pt>
                <c:pt idx="6" formatCode="General">
                  <c:v>335.03999999999996</c:v>
                </c:pt>
                <c:pt idx="7" formatCode="General">
                  <c:v>335.03999999999996</c:v>
                </c:pt>
                <c:pt idx="8" formatCode="General">
                  <c:v>368.54399999999998</c:v>
                </c:pt>
                <c:pt idx="9" formatCode="General">
                  <c:v>1055.376</c:v>
                </c:pt>
              </c:numCache>
            </c:numRef>
          </c:val>
          <c:smooth val="0"/>
        </c:ser>
        <c:ser>
          <c:idx val="3"/>
          <c:order val="3"/>
          <c:tx>
            <c:v>20.8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1,'Tumour Growth'!$H$21,'Tumour Growth'!$L$21,'Tumour Growth'!$P$21,'Tumour Growth'!$T$21,'Tumour Growth'!$X$21,'Tumour Growth'!$AB$21,'Tumour Growth'!$AF$21,'Tumour Growth'!$AJ$21,'Tumour Growth'!$AN$21,'Tumour Growth'!$AR$21,'Tumour Growth'!$AV$21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153.93803249999999</c:v>
                </c:pt>
                <c:pt idx="3">
                  <c:v>153.90899999999999</c:v>
                </c:pt>
                <c:pt idx="4" formatCode="General">
                  <c:v>150.768</c:v>
                </c:pt>
                <c:pt idx="5" formatCode="General">
                  <c:v>466.43849999999998</c:v>
                </c:pt>
                <c:pt idx="6" formatCode="General">
                  <c:v>680.55</c:v>
                </c:pt>
                <c:pt idx="7" formatCode="General">
                  <c:v>680.55</c:v>
                </c:pt>
                <c:pt idx="8" formatCode="General">
                  <c:v>979.99199999999996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4"/>
          <c:order val="4"/>
          <c:tx>
            <c:v>20.9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2,'Tumour Growth'!$H$22,'Tumour Growth'!$L$22,'Tumour Growth'!$P$22,'Tumour Growth'!$T$22,'Tumour Growth'!$X$22,'Tumour Growth'!$AB$22,'Tumour Growth'!$AF$22,'Tumour Growth'!$AJ$22,'Tumour Growth'!$AN$22,'Tumour Growth'!$AR$22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0</c:v>
                </c:pt>
                <c:pt idx="2">
                  <c:v>179.59437124999999</c:v>
                </c:pt>
                <c:pt idx="3">
                  <c:v>230.86349999999999</c:v>
                </c:pt>
                <c:pt idx="4" formatCode="General">
                  <c:v>256.51499999999999</c:v>
                </c:pt>
                <c:pt idx="5" formatCode="General">
                  <c:v>424.03499999999997</c:v>
                </c:pt>
                <c:pt idx="6" formatCode="General">
                  <c:v>575.84999999999991</c:v>
                </c:pt>
                <c:pt idx="7" formatCode="General">
                  <c:v>575.84999999999991</c:v>
                </c:pt>
                <c:pt idx="8" formatCode="General">
                  <c:v>1150.1295</c:v>
                </c:pt>
              </c:numCache>
            </c:numRef>
          </c:val>
          <c:smooth val="0"/>
        </c:ser>
        <c:ser>
          <c:idx val="5"/>
          <c:order val="5"/>
          <c:tx>
            <c:v>20.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2,'Tumour Growth'!$H$23,'Tumour Growth'!$L$23,'Tumour Growth'!$P$23,'Tumour Growth'!$T$23,'Tumour Growth'!$X$23,'Tumour Growth'!$AB$23,'Tumour Growth'!$AF$23,'Tumour Growth'!$AJ$23,'Tumour Growth'!$AN$23,'Tumour Growth'!$AR$23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0</c:v>
                </c:pt>
                <c:pt idx="2">
                  <c:v>75.398219999999995</c:v>
                </c:pt>
                <c:pt idx="3">
                  <c:v>169.61399999999998</c:v>
                </c:pt>
                <c:pt idx="4" formatCode="General">
                  <c:v>188.45999999999998</c:v>
                </c:pt>
                <c:pt idx="5" formatCode="General">
                  <c:v>256.51499999999999</c:v>
                </c:pt>
                <c:pt idx="6" formatCode="General">
                  <c:v>335.03999999999996</c:v>
                </c:pt>
                <c:pt idx="7" formatCode="General">
                  <c:v>402.048</c:v>
                </c:pt>
                <c:pt idx="8" formatCode="General">
                  <c:v>466.43849999999998</c:v>
                </c:pt>
                <c:pt idx="9" formatCode="General">
                  <c:v>1238.6009999999999</c:v>
                </c:pt>
              </c:numCache>
            </c:numRef>
          </c:val>
          <c:smooth val="0"/>
        </c:ser>
        <c:ser>
          <c:idx val="6"/>
          <c:order val="6"/>
          <c:tx>
            <c:v>20.1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24,'Tumour Growth'!$L$24,'Tumour Growth'!$P$24,'Tumour Growth'!$T$24,'Tumour Growth'!$X$24,'Tumour Growth'!$AB$24,'Tumour Growth'!$AF$24,'Tumour Growth'!$AJ$24,'Tumour Growth'!$AN$24)</c:f>
              <c:numCache>
                <c:formatCode>0.00</c:formatCode>
                <c:ptCount val="10"/>
                <c:pt idx="0" formatCode="General">
                  <c:v>0</c:v>
                </c:pt>
                <c:pt idx="1">
                  <c:v>0</c:v>
                </c:pt>
                <c:pt idx="2">
                  <c:v>91.629781249999994</c:v>
                </c:pt>
                <c:pt idx="3">
                  <c:v>150.768</c:v>
                </c:pt>
                <c:pt idx="4" formatCode="General">
                  <c:v>130.875</c:v>
                </c:pt>
                <c:pt idx="5" formatCode="General">
                  <c:v>256.51499999999999</c:v>
                </c:pt>
                <c:pt idx="6" formatCode="General">
                  <c:v>307.81799999999998</c:v>
                </c:pt>
                <c:pt idx="7" formatCode="General">
                  <c:v>760.12199999999996</c:v>
                </c:pt>
                <c:pt idx="8" formatCode="General">
                  <c:v>760.12199999999996</c:v>
                </c:pt>
                <c:pt idx="9" formatCode="General">
                  <c:v>1238.6009999999999</c:v>
                </c:pt>
              </c:numCache>
            </c:numRef>
          </c:val>
          <c:smooth val="0"/>
        </c:ser>
        <c:ser>
          <c:idx val="7"/>
          <c:order val="7"/>
          <c:tx>
            <c:v>31.58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25,'Tumour Growth'!$L$25,'Tumour Growth'!$P$25,'Tumour Growth'!$T$25,'Tumour Growth'!$X$25,'Tumour Growth'!$AB$25,'Tumour Growth'!$AF$25,'Tumour Growth'!$AJ$25,'Tumour Growth'!$AN$25,'Tumour Growth'!$AR$25,'Tumour Growth'!$AV$25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.1887902000000006</c:v>
                </c:pt>
                <c:pt idx="2">
                  <c:v>4.18879</c:v>
                </c:pt>
                <c:pt idx="3">
                  <c:v>150.768</c:v>
                </c:pt>
                <c:pt idx="4" formatCode="General">
                  <c:v>230.86349999999999</c:v>
                </c:pt>
                <c:pt idx="5" formatCode="General">
                  <c:v>424.03499999999997</c:v>
                </c:pt>
                <c:pt idx="6" formatCode="General">
                  <c:v>424.03499999999997</c:v>
                </c:pt>
                <c:pt idx="7" formatCode="General">
                  <c:v>466.43849999999998</c:v>
                </c:pt>
                <c:pt idx="8" formatCode="General">
                  <c:v>680.55</c:v>
                </c:pt>
                <c:pt idx="9" formatCode="General">
                  <c:v>1130.76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8"/>
          <c:order val="8"/>
          <c:tx>
            <c:v>31.6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26,'Tumour Growth'!$L$26,'Tumour Growth'!$P$26,'Tumour Growth'!$T$26,'Tumour Growth'!$X$26,'Tumour Growth'!$AB$26,'Tumour Growth'!$AF$26,'Tumour Growth'!$AJ$26,'Tumour Growth'!$AN$26,'Tumour Growth'!$AR$26,'Tumour Growth'!$AV$26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65.449846875000006</c:v>
                </c:pt>
                <c:pt idx="2">
                  <c:v>91.629781249999994</c:v>
                </c:pt>
                <c:pt idx="3">
                  <c:v>50.256</c:v>
                </c:pt>
                <c:pt idx="4" formatCode="General">
                  <c:v>78.524999999999991</c:v>
                </c:pt>
                <c:pt idx="5" formatCode="General">
                  <c:v>368.54399999999998</c:v>
                </c:pt>
                <c:pt idx="6" formatCode="General">
                  <c:v>368.54399999999998</c:v>
                </c:pt>
                <c:pt idx="7" formatCode="General">
                  <c:v>466.43849999999998</c:v>
                </c:pt>
                <c:pt idx="8" formatCode="General">
                  <c:v>508.84199999999998</c:v>
                </c:pt>
                <c:pt idx="9" formatCode="General">
                  <c:v>1055.376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9"/>
          <c:order val="9"/>
          <c:tx>
            <c:v>31.6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G$23,'Tumour Growth'!$H$27,'Tumour Growth'!$L$27,'Tumour Growth'!$Q$27,'Tumour Growth'!$T$27,'Tumour Growth'!$X$27,'Tumour Growth'!$AB$27,'Tumour Growth'!$AF$27,'Tumour Growth'!$AJ$27,'Tumour Growth'!$AN$27)</c:f>
              <c:numCache>
                <c:formatCode>0.00</c:formatCode>
                <c:ptCount val="10"/>
                <c:pt idx="0" formatCode="General">
                  <c:v>0</c:v>
                </c:pt>
                <c:pt idx="1">
                  <c:v>4.1887902000000006</c:v>
                </c:pt>
                <c:pt idx="2">
                  <c:v>78.539812499999996</c:v>
                </c:pt>
                <c:pt idx="3" formatCode="0.000">
                  <c:v>122.86545000000001</c:v>
                </c:pt>
                <c:pt idx="4" formatCode="General">
                  <c:v>381.63149999999996</c:v>
                </c:pt>
                <c:pt idx="5" formatCode="General">
                  <c:v>575.84999999999991</c:v>
                </c:pt>
                <c:pt idx="6" formatCode="General">
                  <c:v>904.60799999999995</c:v>
                </c:pt>
                <c:pt idx="7" formatCode="General">
                  <c:v>979.99199999999996</c:v>
                </c:pt>
                <c:pt idx="8" formatCode="General">
                  <c:v>979.99199999999996</c:v>
                </c:pt>
                <c:pt idx="9" formatCode="General">
                  <c:v>1238.600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359168"/>
        <c:axId val="164373248"/>
      </c:lineChart>
      <c:dateAx>
        <c:axId val="164359168"/>
        <c:scaling>
          <c:orientation val="minMax"/>
          <c:max val="28"/>
        </c:scaling>
        <c:delete val="0"/>
        <c:axPos val="b"/>
        <c:numFmt formatCode="General" sourceLinked="1"/>
        <c:majorTickMark val="out"/>
        <c:minorTickMark val="none"/>
        <c:tickLblPos val="nextTo"/>
        <c:crossAx val="164373248"/>
        <c:crosses val="autoZero"/>
        <c:auto val="0"/>
        <c:lblOffset val="100"/>
        <c:baseTimeUnit val="days"/>
        <c:majorUnit val="4"/>
        <c:majorTimeUnit val="days"/>
      </c:dateAx>
      <c:valAx>
        <c:axId val="164373248"/>
        <c:scaling>
          <c:orientation val="minMax"/>
          <c:max val="140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16435916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667237924338102"/>
          <c:y val="3.4902807580851077E-2"/>
          <c:w val="0.79952359880924151"/>
          <c:h val="0.75290257059576093"/>
        </c:manualLayout>
      </c:layout>
      <c:lineChart>
        <c:grouping val="standard"/>
        <c:varyColors val="0"/>
        <c:ser>
          <c:idx val="0"/>
          <c:order val="0"/>
          <c:tx>
            <c:v>9.77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0,'Tumour Growth'!$H$28,'Tumour Growth'!$L$28,'Tumour Growth'!$P$28,'Tumour Growth'!$T$28,'Tumour Growth'!$X$28,'Tumour Growth'!$AB$28,'Tumour Growth'!$AF$28,'Tumour Growth'!$AJ$28,'Tumour Growth'!$AN$28,'Tumour Growth'!$AR$28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131.9468913</c:v>
                </c:pt>
                <c:pt idx="2">
                  <c:v>205.25071</c:v>
                </c:pt>
                <c:pt idx="3">
                  <c:v>268.03199999999998</c:v>
                </c:pt>
                <c:pt idx="4" formatCode="General">
                  <c:v>268.03199999999998</c:v>
                </c:pt>
                <c:pt idx="5" formatCode="General">
                  <c:v>381.63149999999996</c:v>
                </c:pt>
                <c:pt idx="6" formatCode="General">
                  <c:v>696.77850000000001</c:v>
                </c:pt>
                <c:pt idx="7" formatCode="General">
                  <c:v>696.77850000000001</c:v>
                </c:pt>
                <c:pt idx="8" formatCode="General">
                  <c:v>904.60799999999995</c:v>
                </c:pt>
                <c:pt idx="9" formatCode="General">
                  <c:v>1150.1295</c:v>
                </c:pt>
              </c:numCache>
            </c:numRef>
          </c:val>
          <c:smooth val="0"/>
        </c:ser>
        <c:ser>
          <c:idx val="1"/>
          <c:order val="1"/>
          <c:tx>
            <c:v>9.78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29,'Tumour Growth'!$L$29,'Tumour Growth'!$P$29,'Tumour Growth'!$T$29,'Tumour Growth'!$X$29,'Tumour Growth'!$AB$29,'Tumour Growth'!$AF$29,'Tumour Growth'!$AJ$29,'Tumour Growth'!$AN$29,'Tumour Growth'!$AR$29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4.1887902000000006</c:v>
                </c:pt>
                <c:pt idx="2">
                  <c:v>4.18879</c:v>
                </c:pt>
                <c:pt idx="3">
                  <c:v>6.282</c:v>
                </c:pt>
                <c:pt idx="4" formatCode="General">
                  <c:v>14.134499999999999</c:v>
                </c:pt>
                <c:pt idx="5" formatCode="General">
                  <c:v>104.69999999999999</c:v>
                </c:pt>
                <c:pt idx="6" formatCode="General">
                  <c:v>207.30599999999998</c:v>
                </c:pt>
                <c:pt idx="7" formatCode="General">
                  <c:v>207.30599999999998</c:v>
                </c:pt>
                <c:pt idx="8" formatCode="General">
                  <c:v>335.03999999999996</c:v>
                </c:pt>
                <c:pt idx="9" formatCode="General">
                  <c:v>904.60799999999995</c:v>
                </c:pt>
              </c:numCache>
            </c:numRef>
          </c:val>
          <c:smooth val="0"/>
        </c:ser>
        <c:ser>
          <c:idx val="2"/>
          <c:order val="2"/>
          <c:tx>
            <c:v>9.79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30,'Tumour Growth'!$L$30,'Tumour Growth'!$P$30,'Tumour Growth'!$T$30,'Tumour Growth'!$X$30,'Tumour Growth'!$AB$30,'Tumour Growth'!$AF$30,'Tumour Growth'!$AJ$30,'Tumour Growth'!$AN$30,'Tumour Growth'!$AR$30,'Tumour Growth'!$AV$30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41.887902000000004</c:v>
                </c:pt>
                <c:pt idx="2">
                  <c:v>256.56338749999998</c:v>
                </c:pt>
                <c:pt idx="3">
                  <c:v>424.03499999999997</c:v>
                </c:pt>
                <c:pt idx="4" formatCode="General">
                  <c:v>424.03499999999997</c:v>
                </c:pt>
                <c:pt idx="5" formatCode="General">
                  <c:v>696.77850000000001</c:v>
                </c:pt>
                <c:pt idx="6" formatCode="General">
                  <c:v>680.55</c:v>
                </c:pt>
                <c:pt idx="7" formatCode="General">
                  <c:v>696.77850000000001</c:v>
                </c:pt>
                <c:pt idx="8" formatCode="General">
                  <c:v>696.77850000000001</c:v>
                </c:pt>
                <c:pt idx="9" formatCode="General">
                  <c:v>1238.6009999999999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3"/>
          <c:order val="3"/>
          <c:tx>
            <c:v>9.8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31,'Tumour Growth'!$L$31,'Tumour Growth'!$P$31,'Tumour Growth'!$T$31,'Tumour Growth'!$X$31,'Tumour Growth'!$AB$31,'Tumour Growth'!$AF$31,'Tumour Growth'!$AJ$31,'Tumour Growth'!$AN$31,'Tumour Growth'!$AR$31,'Tumour Growth'!$AV$31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78.539816250000015</c:v>
                </c:pt>
                <c:pt idx="2">
                  <c:v>205.25071</c:v>
                </c:pt>
                <c:pt idx="3">
                  <c:v>205.21199999999999</c:v>
                </c:pt>
                <c:pt idx="4" formatCode="General">
                  <c:v>205.21199999999999</c:v>
                </c:pt>
                <c:pt idx="5" formatCode="General">
                  <c:v>268.03199999999998</c:v>
                </c:pt>
                <c:pt idx="6" formatCode="General">
                  <c:v>335.03999999999996</c:v>
                </c:pt>
                <c:pt idx="7" formatCode="General">
                  <c:v>335.03999999999996</c:v>
                </c:pt>
                <c:pt idx="8" formatCode="General">
                  <c:v>268.03199999999998</c:v>
                </c:pt>
                <c:pt idx="9" formatCode="General">
                  <c:v>904.60799999999995</c:v>
                </c:pt>
              </c:numCache>
            </c:numRef>
          </c:val>
          <c:smooth val="0"/>
        </c:ser>
        <c:ser>
          <c:idx val="4"/>
          <c:order val="4"/>
          <c:tx>
            <c:v>9.8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G$23,'Tumour Growth'!$H$32,'Tumour Growth'!$L$32,'Tumour Growth'!$P$32,'Tumour Growth'!$T$32,'Tumour Growth'!$X$32,'Tumour Growth'!$AB$32,'Tumour Growth'!$AF$32,'Tumour Growth'!$AJ$32,'Tumour Growth'!$AN$32,'Tumour Growth'!$AR$32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67.020643200000009</c:v>
                </c:pt>
                <c:pt idx="2">
                  <c:v>188.49555000000001</c:v>
                </c:pt>
                <c:pt idx="3">
                  <c:v>169.61399999999998</c:v>
                </c:pt>
                <c:pt idx="4" formatCode="General">
                  <c:v>230.86349999999999</c:v>
                </c:pt>
                <c:pt idx="5" formatCode="General">
                  <c:v>575.84999999999991</c:v>
                </c:pt>
                <c:pt idx="6" formatCode="General">
                  <c:v>760.12199999999996</c:v>
                </c:pt>
                <c:pt idx="7" formatCode="General">
                  <c:v>904.60799999999995</c:v>
                </c:pt>
                <c:pt idx="8" formatCode="General">
                  <c:v>823.46549999999991</c:v>
                </c:pt>
                <c:pt idx="9" formatCode="General">
                  <c:v>1150.1295</c:v>
                </c:pt>
              </c:numCache>
            </c:numRef>
          </c:val>
          <c:smooth val="0"/>
        </c:ser>
        <c:ser>
          <c:idx val="5"/>
          <c:order val="5"/>
          <c:tx>
            <c:v>18.99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24,'Tumour Growth'!$H$33,'Tumour Growth'!$L$33,'Tumour Growth'!$P$33,'Tumour Growth'!$T$33,'Tumour Growth'!$X$33,'Tumour Growth'!$AB$33,'Tumour Growth'!$AF$33,'Tumour Growth'!$AJ$33,'Tumour Growth'!$AN$33,'Tumour Growth'!$AR$33)</c:f>
              <c:numCache>
                <c:formatCode>0.00</c:formatCode>
                <c:ptCount val="11"/>
                <c:pt idx="0" formatCode="General">
                  <c:v>0</c:v>
                </c:pt>
                <c:pt idx="1">
                  <c:v>41.887902000000004</c:v>
                </c:pt>
                <c:pt idx="2">
                  <c:v>207.34510499999999</c:v>
                </c:pt>
                <c:pt idx="3">
                  <c:v>523.5</c:v>
                </c:pt>
                <c:pt idx="4" formatCode="General">
                  <c:v>575.84999999999991</c:v>
                </c:pt>
                <c:pt idx="5" formatCode="General">
                  <c:v>628.19999999999993</c:v>
                </c:pt>
                <c:pt idx="6" formatCode="General">
                  <c:v>760.12199999999996</c:v>
                </c:pt>
                <c:pt idx="7" formatCode="General">
                  <c:v>760.12199999999996</c:v>
                </c:pt>
                <c:pt idx="8" formatCode="General">
                  <c:v>760.12199999999996</c:v>
                </c:pt>
                <c:pt idx="9" formatCode="General">
                  <c:v>1238.6009999999999</c:v>
                </c:pt>
              </c:numCache>
            </c:numRef>
          </c:val>
          <c:smooth val="0"/>
        </c:ser>
        <c:ser>
          <c:idx val="6"/>
          <c:order val="6"/>
          <c:tx>
            <c:v>18.1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G$37,'Tumour Growth'!$H$34,'Tumour Growth'!$L$34,'Tumour Growth'!$P$34,'Tumour Growth'!$T$34,'Tumour Growth'!$X$34,'Tumour Growth'!$AB$34,'Tumour Growth'!$AF$34,'Tumour Growth'!$AJ$34,'Tumour Growth'!$AN$34,'Tumour Growth'!$AR$34,'Tumour Growth'!$AV$34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91.629785625000011</c:v>
                </c:pt>
                <c:pt idx="2">
                  <c:v>205.25071</c:v>
                </c:pt>
                <c:pt idx="3">
                  <c:v>205.21199999999999</c:v>
                </c:pt>
                <c:pt idx="4" formatCode="General">
                  <c:v>205.21199999999999</c:v>
                </c:pt>
                <c:pt idx="5" formatCode="General">
                  <c:v>575.84999999999991</c:v>
                </c:pt>
                <c:pt idx="6" formatCode="General">
                  <c:v>628.19999999999993</c:v>
                </c:pt>
                <c:pt idx="7" formatCode="General">
                  <c:v>628.19999999999993</c:v>
                </c:pt>
                <c:pt idx="8" formatCode="General">
                  <c:v>680.55</c:v>
                </c:pt>
                <c:pt idx="9" formatCode="General">
                  <c:v>1150.1295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7"/>
          <c:order val="7"/>
          <c:tx>
            <c:v>30.53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37,'Tumour Growth'!$H$35,'Tumour Growth'!$L$35,'Tumour Growth'!$P$35,'Tumour Growth'!$T$35,'Tumour Growth'!$X$35,'Tumour Growth'!$AB$35,'Tumour Growth'!$AF$35,'Tumour Growth'!$AJ$35,'Tumour Growth'!$AN$35,'Tumour Growth'!$AR$35,'Tumour Growth'!$AV$35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65.449846875000006</c:v>
                </c:pt>
                <c:pt idx="2">
                  <c:v>113.09733</c:v>
                </c:pt>
                <c:pt idx="3">
                  <c:v>113.07599999999999</c:v>
                </c:pt>
                <c:pt idx="4" formatCode="General">
                  <c:v>113.07599999999999</c:v>
                </c:pt>
                <c:pt idx="5" formatCode="General">
                  <c:v>205.21199999999999</c:v>
                </c:pt>
                <c:pt idx="6" formatCode="General">
                  <c:v>205.21199999999999</c:v>
                </c:pt>
                <c:pt idx="7" formatCode="General">
                  <c:v>307.81799999999998</c:v>
                </c:pt>
                <c:pt idx="8" formatCode="General">
                  <c:v>256.51499999999999</c:v>
                </c:pt>
                <c:pt idx="9" formatCode="General">
                  <c:v>979.99199999999996</c:v>
                </c:pt>
                <c:pt idx="11" formatCode="General">
                  <c:v>0</c:v>
                </c:pt>
              </c:numCache>
            </c:numRef>
          </c:val>
          <c:smooth val="0"/>
        </c:ser>
        <c:ser>
          <c:idx val="8"/>
          <c:order val="8"/>
          <c:tx>
            <c:v>30.56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37,'Tumour Growth'!$H$36,'Tumour Growth'!$L$36,'Tumour Growth'!$P$36,'Tumour Growth'!$T$36,'Tumour Growth'!$X$36,'Tumour Growth'!$AB$36)</c:f>
              <c:numCache>
                <c:formatCode>0.00</c:formatCode>
                <c:ptCount val="7"/>
                <c:pt idx="0" formatCode="General">
                  <c:v>0</c:v>
                </c:pt>
                <c:pt idx="1">
                  <c:v>0</c:v>
                </c:pt>
                <c:pt idx="2">
                  <c:v>282.21972625000001</c:v>
                </c:pt>
                <c:pt idx="3">
                  <c:v>256.51499999999999</c:v>
                </c:pt>
                <c:pt idx="4" formatCode="General">
                  <c:v>256.51499999999999</c:v>
                </c:pt>
                <c:pt idx="5" formatCode="General">
                  <c:v>904.60799999999995</c:v>
                </c:pt>
                <c:pt idx="6" formatCode="General">
                  <c:v>1150.1295</c:v>
                </c:pt>
              </c:numCache>
            </c:numRef>
          </c:val>
          <c:smooth val="0"/>
        </c:ser>
        <c:ser>
          <c:idx val="9"/>
          <c:order val="9"/>
          <c:tx>
            <c:v>30.57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F$58:$R$5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6</c:v>
                </c:pt>
                <c:pt idx="9">
                  <c:v>19</c:v>
                </c:pt>
                <c:pt idx="10">
                  <c:v>21</c:v>
                </c:pt>
                <c:pt idx="11">
                  <c:v>23</c:v>
                </c:pt>
                <c:pt idx="12">
                  <c:v>26</c:v>
                </c:pt>
              </c:numCache>
            </c:numRef>
          </c:cat>
          <c:val>
            <c:numRef>
              <c:f>('Tumour Growth'!$F$37,'Tumour Growth'!$H$37,'Tumour Growth'!$L$37,'Tumour Growth'!$P$37,'Tumour Growth'!$T$37,'Tumour Growth'!$X$37,'Tumour Growth'!$AB$37,'Tumour Growth'!$AF$37,'Tumour Growth'!$AJ$37,'Tumour Growth'!$AN$37,'Tumour Growth'!$AR$37,'Tumour Growth'!$AV$37)</c:f>
              <c:numCache>
                <c:formatCode>0.00</c:formatCode>
                <c:ptCount val="12"/>
                <c:pt idx="0" formatCode="General">
                  <c:v>0</c:v>
                </c:pt>
                <c:pt idx="1">
                  <c:v>0</c:v>
                </c:pt>
                <c:pt idx="2">
                  <c:v>32.986721250000002</c:v>
                </c:pt>
                <c:pt idx="3">
                  <c:v>51.826499999999996</c:v>
                </c:pt>
                <c:pt idx="4" formatCode="General">
                  <c:v>51.826499999999996</c:v>
                </c:pt>
                <c:pt idx="5" formatCode="General">
                  <c:v>188.45999999999998</c:v>
                </c:pt>
                <c:pt idx="6" formatCode="General">
                  <c:v>307.81799999999998</c:v>
                </c:pt>
                <c:pt idx="7" formatCode="General">
                  <c:v>508.84199999999998</c:v>
                </c:pt>
                <c:pt idx="8" formatCode="General">
                  <c:v>551.24549999999999</c:v>
                </c:pt>
                <c:pt idx="9" formatCode="General">
                  <c:v>1130.76</c:v>
                </c:pt>
                <c:pt idx="11" formatCode="General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412416"/>
        <c:axId val="164430976"/>
      </c:lineChart>
      <c:dateAx>
        <c:axId val="164412416"/>
        <c:scaling>
          <c:orientation val="minMax"/>
          <c:max val="28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NZ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since implnatation</a:t>
                </a:r>
                <a:r>
                  <a:rPr lang="en-NZ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days)</a:t>
                </a:r>
                <a:endParaRPr lang="en-NZ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430976"/>
        <c:crossesAt val="0"/>
        <c:auto val="0"/>
        <c:lblOffset val="100"/>
        <c:baseTimeUnit val="days"/>
        <c:majorUnit val="4"/>
        <c:majorTimeUnit val="days"/>
      </c:dateAx>
      <c:valAx>
        <c:axId val="164430976"/>
        <c:scaling>
          <c:orientation val="minMax"/>
          <c:max val="1400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low"/>
        <c:crossAx val="16441241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519423439927353"/>
          <c:y val="3.2024639591343364E-2"/>
          <c:w val="0.77419735160325931"/>
          <c:h val="0.78612202909963202"/>
        </c:manualLayout>
      </c:layout>
      <c:lineChart>
        <c:grouping val="standard"/>
        <c:varyColors val="0"/>
        <c:ser>
          <c:idx val="0"/>
          <c:order val="0"/>
          <c:tx>
            <c:strRef>
              <c:f>'Tumour Growth'!$Y$40</c:f>
              <c:strCache>
                <c:ptCount val="1"/>
                <c:pt idx="0">
                  <c:v>43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0:$AH$40</c:f>
              <c:numCache>
                <c:formatCode>0.00</c:formatCode>
                <c:ptCount val="9"/>
                <c:pt idx="0" formatCode="General">
                  <c:v>0</c:v>
                </c:pt>
                <c:pt idx="1">
                  <c:v>23.561944875000002</c:v>
                </c:pt>
                <c:pt idx="2">
                  <c:v>33.51032</c:v>
                </c:pt>
                <c:pt idx="3">
                  <c:v>113.07599999999999</c:v>
                </c:pt>
                <c:pt idx="4" formatCode="General">
                  <c:v>113.07599999999999</c:v>
                </c:pt>
                <c:pt idx="5" formatCode="General">
                  <c:v>205.21199999999999</c:v>
                </c:pt>
                <c:pt idx="6" formatCode="General">
                  <c:v>205.21199999999999</c:v>
                </c:pt>
                <c:pt idx="7" formatCode="General">
                  <c:v>268.03199999999998</c:v>
                </c:pt>
                <c:pt idx="8" formatCode="General">
                  <c:v>823.4654999999999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Tumour Growth'!$Y$41</c:f>
              <c:strCache>
                <c:ptCount val="1"/>
                <c:pt idx="0">
                  <c:v>44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1:$AG$41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78.539816250000015</c:v>
                </c:pt>
                <c:pt idx="2">
                  <c:v>179.59437124999999</c:v>
                </c:pt>
                <c:pt idx="3">
                  <c:v>628.19999999999993</c:v>
                </c:pt>
                <c:pt idx="4" formatCode="General">
                  <c:v>904.6079999999999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Tumour Growth'!$Y$42</c:f>
              <c:strCache>
                <c:ptCount val="1"/>
                <c:pt idx="0">
                  <c:v>60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2:$AG$42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94.247779500000007</c:v>
                </c:pt>
                <c:pt idx="2">
                  <c:v>551.34948374999999</c:v>
                </c:pt>
                <c:pt idx="3">
                  <c:v>886.8089999999999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Tumour Growth'!$Y$43</c:f>
              <c:strCache>
                <c:ptCount val="1"/>
                <c:pt idx="0">
                  <c:v>62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3:$AG$43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33.510321600000005</c:v>
                </c:pt>
                <c:pt idx="2">
                  <c:v>65.449843749999999</c:v>
                </c:pt>
                <c:pt idx="3">
                  <c:v>575.84999999999991</c:v>
                </c:pt>
                <c:pt idx="4" formatCode="General">
                  <c:v>904.6079999999999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Tumour Growth'!$Y$44</c:f>
              <c:strCache>
                <c:ptCount val="1"/>
                <c:pt idx="0">
                  <c:v>63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4:$AG$44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41.887902000000004</c:v>
                </c:pt>
                <c:pt idx="2">
                  <c:v>91.629781249999994</c:v>
                </c:pt>
                <c:pt idx="3">
                  <c:v>50.256</c:v>
                </c:pt>
                <c:pt idx="4" formatCode="General">
                  <c:v>134.01599999999999</c:v>
                </c:pt>
                <c:pt idx="5" formatCode="General">
                  <c:v>381.63149999999996</c:v>
                </c:pt>
                <c:pt idx="6" formatCode="General">
                  <c:v>523.5</c:v>
                </c:pt>
                <c:pt idx="7" formatCode="General">
                  <c:v>801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Tumour Growth'!$Y$45</c:f>
              <c:strCache>
                <c:ptCount val="1"/>
                <c:pt idx="0">
                  <c:v>66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5:$AG$45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268.08257280000004</c:v>
                </c:pt>
                <c:pt idx="2">
                  <c:v>368.61351999999999</c:v>
                </c:pt>
                <c:pt idx="3">
                  <c:v>523.5</c:v>
                </c:pt>
                <c:pt idx="4" formatCode="General">
                  <c:v>801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Tumour Growth'!$Y$46</c:f>
              <c:strCache>
                <c:ptCount val="1"/>
                <c:pt idx="0">
                  <c:v>68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6:$AG$46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0</c:v>
                </c:pt>
                <c:pt idx="2">
                  <c:v>33.51032</c:v>
                </c:pt>
                <c:pt idx="3">
                  <c:v>424.03499999999997</c:v>
                </c:pt>
                <c:pt idx="4" formatCode="General">
                  <c:v>801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Tumour Growth'!$Y$47</c:f>
              <c:strCache>
                <c:ptCount val="1"/>
                <c:pt idx="0">
                  <c:v>70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7:$AH$47</c:f>
              <c:numCache>
                <c:formatCode>0.00</c:formatCode>
                <c:ptCount val="9"/>
                <c:pt idx="0" formatCode="General">
                  <c:v>0</c:v>
                </c:pt>
                <c:pt idx="1">
                  <c:v>14.137166925000002</c:v>
                </c:pt>
                <c:pt idx="2">
                  <c:v>33.51032</c:v>
                </c:pt>
                <c:pt idx="3">
                  <c:v>131.922</c:v>
                </c:pt>
                <c:pt idx="4" formatCode="General">
                  <c:v>179.56049999999999</c:v>
                </c:pt>
                <c:pt idx="5" formatCode="General">
                  <c:v>179.56049999999999</c:v>
                </c:pt>
                <c:pt idx="6" formatCode="General">
                  <c:v>205.21199999999999</c:v>
                </c:pt>
                <c:pt idx="7" formatCode="General">
                  <c:v>424.03499999999997</c:v>
                </c:pt>
                <c:pt idx="8" formatCode="General">
                  <c:v>823.46549999999991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Tumour Growth'!$Y$48</c:f>
              <c:strCache>
                <c:ptCount val="1"/>
                <c:pt idx="0">
                  <c:v>75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8:$AG$48</c:f>
              <c:numCache>
                <c:formatCode>0.00</c:formatCode>
                <c:ptCount val="8"/>
                <c:pt idx="0" formatCode="General">
                  <c:v>0</c:v>
                </c:pt>
                <c:pt idx="1">
                  <c:v>0</c:v>
                </c:pt>
                <c:pt idx="2">
                  <c:v>23.561943750000001</c:v>
                </c:pt>
                <c:pt idx="3">
                  <c:v>113.07599999999999</c:v>
                </c:pt>
                <c:pt idx="4" formatCode="General">
                  <c:v>58.631999999999998</c:v>
                </c:pt>
                <c:pt idx="5" formatCode="General">
                  <c:v>65.4375</c:v>
                </c:pt>
                <c:pt idx="6" formatCode="General">
                  <c:v>91.612499999999997</c:v>
                </c:pt>
                <c:pt idx="7" formatCode="General">
                  <c:v>823.46549999999991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Tumour Growth'!$Y$49</c:f>
              <c:strCache>
                <c:ptCount val="1"/>
                <c:pt idx="0">
                  <c:v>76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49:$AF$49</c:f>
              <c:numCache>
                <c:formatCode>0.00</c:formatCode>
                <c:ptCount val="7"/>
                <c:pt idx="0" formatCode="General">
                  <c:v>0</c:v>
                </c:pt>
                <c:pt idx="1">
                  <c:v>33.510321600000005</c:v>
                </c:pt>
                <c:pt idx="2">
                  <c:v>41.887900000000002</c:v>
                </c:pt>
                <c:pt idx="3">
                  <c:v>65.4375</c:v>
                </c:pt>
                <c:pt idx="4" formatCode="General">
                  <c:v>188.45999999999998</c:v>
                </c:pt>
                <c:pt idx="5" formatCode="General">
                  <c:v>633.43499999999995</c:v>
                </c:pt>
                <c:pt idx="6" formatCode="General">
                  <c:v>823.4654999999999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486144"/>
        <c:axId val="164496128"/>
      </c:lineChart>
      <c:dateAx>
        <c:axId val="164486144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64496128"/>
        <c:crosses val="autoZero"/>
        <c:auto val="0"/>
        <c:lblOffset val="100"/>
        <c:baseTimeUnit val="days"/>
        <c:majorUnit val="2"/>
        <c:majorTimeUnit val="days"/>
      </c:dateAx>
      <c:valAx>
        <c:axId val="164496128"/>
        <c:scaling>
          <c:orientation val="minMax"/>
          <c:max val="120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900" b="1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NZ" sz="9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mour</a:t>
                </a:r>
                <a:r>
                  <a:rPr lang="en-NZ" sz="900" b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olume (mm</a:t>
                </a:r>
                <a:r>
                  <a:rPr lang="en-NZ" sz="900" b="1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NZ" sz="900" b="1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NZ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6.0838405440412332E-3"/>
              <c:y val="0.163992869875222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64486144"/>
        <c:crosses val="autoZero"/>
        <c:crossBetween val="between"/>
        <c:majorUnit val="200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0042253509649"/>
          <c:y val="3.6998365428588247E-2"/>
          <c:w val="0.80204033790855589"/>
          <c:h val="0.75123385958664712"/>
        </c:manualLayout>
      </c:layout>
      <c:lineChart>
        <c:grouping val="standar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0:$AD$60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1.887902000000004</c:v>
                </c:pt>
                <c:pt idx="2">
                  <c:v>131.94688500000001</c:v>
                </c:pt>
                <c:pt idx="3">
                  <c:v>381.63149999999996</c:v>
                </c:pt>
                <c:pt idx="4" formatCode="General">
                  <c:v>628.19999999999993</c:v>
                </c:pt>
              </c:numCache>
            </c:numRef>
          </c:val>
          <c:smooth val="0"/>
        </c:ser>
        <c:ser>
          <c:idx val="1"/>
          <c:order val="1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1:$AD$61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8.849555900000002</c:v>
                </c:pt>
                <c:pt idx="2">
                  <c:v>50.265479999999997</c:v>
                </c:pt>
                <c:pt idx="3">
                  <c:v>65.4375</c:v>
                </c:pt>
                <c:pt idx="4" formatCode="General">
                  <c:v>696.77850000000001</c:v>
                </c:pt>
              </c:numCache>
            </c:numRef>
          </c:val>
          <c:smooth val="0"/>
        </c:ser>
        <c:ser>
          <c:idx val="2"/>
          <c:order val="2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2:$AD$62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52.35987750000001</c:v>
                </c:pt>
                <c:pt idx="2">
                  <c:v>91.629781249999994</c:v>
                </c:pt>
                <c:pt idx="3">
                  <c:v>523.5</c:v>
                </c:pt>
                <c:pt idx="4" formatCode="General">
                  <c:v>1436.4839999999999</c:v>
                </c:pt>
              </c:numCache>
            </c:numRef>
          </c:val>
          <c:smooth val="0"/>
        </c:ser>
        <c:ser>
          <c:idx val="3"/>
          <c:order val="3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3:$AD$63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32.986722825000001</c:v>
                </c:pt>
                <c:pt idx="2">
                  <c:v>91.629781249999994</c:v>
                </c:pt>
                <c:pt idx="3">
                  <c:v>268.03199999999998</c:v>
                </c:pt>
                <c:pt idx="4" formatCode="General">
                  <c:v>1238.6009999999999</c:v>
                </c:pt>
              </c:numCache>
            </c:numRef>
          </c:val>
          <c:smooth val="0"/>
        </c:ser>
        <c:ser>
          <c:idx val="4"/>
          <c:order val="4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4:$AD$64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0</c:v>
                </c:pt>
                <c:pt idx="2">
                  <c:v>33.51032</c:v>
                </c:pt>
                <c:pt idx="3">
                  <c:v>301.536</c:v>
                </c:pt>
                <c:pt idx="4" formatCode="General">
                  <c:v>696.77850000000001</c:v>
                </c:pt>
              </c:numCache>
            </c:numRef>
          </c:val>
          <c:smooth val="0"/>
        </c:ser>
        <c:ser>
          <c:idx val="5"/>
          <c:order val="5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5:$AD$65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02.62535990000002</c:v>
                </c:pt>
                <c:pt idx="2">
                  <c:v>179.59437124999999</c:v>
                </c:pt>
                <c:pt idx="3">
                  <c:v>508.84199999999998</c:v>
                </c:pt>
              </c:numCache>
            </c:numRef>
          </c:val>
          <c:smooth val="0"/>
        </c:ser>
        <c:ser>
          <c:idx val="6"/>
          <c:order val="6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6:$AD$66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13.09733540000002</c:v>
                </c:pt>
                <c:pt idx="2">
                  <c:v>205.25071</c:v>
                </c:pt>
                <c:pt idx="3">
                  <c:v>381.63149999999996</c:v>
                </c:pt>
              </c:numCache>
            </c:numRef>
          </c:val>
          <c:smooth val="0"/>
        </c:ser>
        <c:ser>
          <c:idx val="7"/>
          <c:order val="7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7:$AD$67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65.449846875000006</c:v>
                </c:pt>
                <c:pt idx="2">
                  <c:v>205.25071</c:v>
                </c:pt>
                <c:pt idx="3">
                  <c:v>904.60799999999995</c:v>
                </c:pt>
              </c:numCache>
            </c:numRef>
          </c:val>
          <c:smooth val="0"/>
        </c:ser>
        <c:ser>
          <c:idx val="8"/>
          <c:order val="8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8:$AD$68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0</c:v>
                </c:pt>
                <c:pt idx="2">
                  <c:v>41.887900000000002</c:v>
                </c:pt>
                <c:pt idx="3">
                  <c:v>696.77850000000001</c:v>
                </c:pt>
              </c:numCache>
            </c:numRef>
          </c:val>
          <c:smooth val="0"/>
        </c:ser>
        <c:ser>
          <c:idx val="9"/>
          <c:order val="9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69:$AD$69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13.09733540000002</c:v>
                </c:pt>
                <c:pt idx="2">
                  <c:v>268.08256</c:v>
                </c:pt>
                <c:pt idx="3">
                  <c:v>1055.37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535680"/>
        <c:axId val="164541952"/>
      </c:lineChart>
      <c:dateAx>
        <c:axId val="164535680"/>
        <c:scaling>
          <c:orientation val="minMax"/>
          <c:max val="20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NZ" sz="1000" b="1" i="0" u="none" strike="noStrike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since implantation (days)</a:t>
                </a:r>
                <a:endParaRPr lang="en-NZ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4541952"/>
        <c:crosses val="autoZero"/>
        <c:auto val="0"/>
        <c:lblOffset val="100"/>
        <c:baseTimeUnit val="days"/>
        <c:majorUnit val="2"/>
        <c:majorTimeUnit val="days"/>
      </c:dateAx>
      <c:valAx>
        <c:axId val="164541952"/>
        <c:scaling>
          <c:orientation val="minMax"/>
          <c:max val="120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9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NZ" sz="9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mour</a:t>
                </a:r>
                <a:r>
                  <a:rPr lang="en-NZ" sz="9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olume (mm</a:t>
                </a:r>
                <a:r>
                  <a:rPr lang="en-NZ" sz="90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NZ" sz="9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NZ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206957756478523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5356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N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997658468317744"/>
          <c:y val="3.5105703793926274E-2"/>
          <c:w val="0.77965741172124059"/>
          <c:h val="0.81126361648869005"/>
        </c:manualLayout>
      </c:layout>
      <c:lineChart>
        <c:grouping val="standar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0:$AD$50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50.26548240000001</c:v>
                </c:pt>
                <c:pt idx="2">
                  <c:v>131.94688500000001</c:v>
                </c:pt>
                <c:pt idx="3">
                  <c:v>904.60799999999995</c:v>
                </c:pt>
              </c:numCache>
            </c:numRef>
          </c:val>
          <c:smooth val="0"/>
        </c:ser>
        <c:ser>
          <c:idx val="1"/>
          <c:order val="1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1:$AD$51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67.55160800000002</c:v>
                </c:pt>
                <c:pt idx="2">
                  <c:v>205.25071</c:v>
                </c:pt>
                <c:pt idx="3">
                  <c:v>628.19999999999993</c:v>
                </c:pt>
              </c:numCache>
            </c:numRef>
          </c:val>
          <c:smooth val="0"/>
        </c:ser>
        <c:ser>
          <c:idx val="2"/>
          <c:order val="2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2:$AD$52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167.55160800000002</c:v>
                </c:pt>
                <c:pt idx="2">
                  <c:v>575.95862499999998</c:v>
                </c:pt>
                <c:pt idx="3" formatCode="General">
                  <c:v>1744.3019999999999</c:v>
                </c:pt>
              </c:numCache>
            </c:numRef>
          </c:val>
          <c:smooth val="0"/>
        </c:ser>
        <c:ser>
          <c:idx val="3"/>
          <c:order val="3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3:$AD$53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.1887902000000006</c:v>
                </c:pt>
                <c:pt idx="2">
                  <c:v>78.539812499999996</c:v>
                </c:pt>
                <c:pt idx="3">
                  <c:v>760.12199999999996</c:v>
                </c:pt>
              </c:numCache>
            </c:numRef>
          </c:val>
          <c:smooth val="0"/>
        </c:ser>
        <c:ser>
          <c:idx val="4"/>
          <c:order val="4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4:$AD$54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0</c:v>
                </c:pt>
                <c:pt idx="2">
                  <c:v>41.887900000000002</c:v>
                </c:pt>
                <c:pt idx="3">
                  <c:v>886.80899999999997</c:v>
                </c:pt>
              </c:numCache>
            </c:numRef>
          </c:val>
          <c:smooth val="0"/>
        </c:ser>
        <c:ser>
          <c:idx val="5"/>
          <c:order val="5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5:$AD$55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.1887902000000006</c:v>
                </c:pt>
                <c:pt idx="2">
                  <c:v>424.11498749999998</c:v>
                </c:pt>
                <c:pt idx="3">
                  <c:v>886.80899999999997</c:v>
                </c:pt>
              </c:numCache>
            </c:numRef>
          </c:val>
          <c:smooth val="0"/>
        </c:ser>
        <c:ser>
          <c:idx val="6"/>
          <c:order val="6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6:$AD$56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4.1887902000000006</c:v>
                </c:pt>
                <c:pt idx="2">
                  <c:v>381.70348875000002</c:v>
                </c:pt>
                <c:pt idx="3">
                  <c:v>732.9</c:v>
                </c:pt>
              </c:numCache>
            </c:numRef>
          </c:val>
          <c:smooth val="0"/>
        </c:ser>
        <c:ser>
          <c:idx val="7"/>
          <c:order val="7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7:$AD$57</c:f>
              <c:numCache>
                <c:formatCode>General</c:formatCode>
                <c:ptCount val="5"/>
                <c:pt idx="0">
                  <c:v>0</c:v>
                </c:pt>
                <c:pt idx="1">
                  <c:v>50.256</c:v>
                </c:pt>
                <c:pt idx="2">
                  <c:v>179.56049999999999</c:v>
                </c:pt>
                <c:pt idx="3">
                  <c:v>628.19999999999993</c:v>
                </c:pt>
                <c:pt idx="4">
                  <c:v>904.60799999999995</c:v>
                </c:pt>
              </c:numCache>
            </c:numRef>
          </c:val>
          <c:smooth val="0"/>
        </c:ser>
        <c:ser>
          <c:idx val="8"/>
          <c:order val="8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8:$AD$58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0</c:v>
                </c:pt>
                <c:pt idx="2">
                  <c:v>58.643059999999998</c:v>
                </c:pt>
                <c:pt idx="3">
                  <c:v>979.99199999999996</c:v>
                </c:pt>
              </c:numCache>
            </c:numRef>
          </c:val>
          <c:smooth val="0"/>
        </c:ser>
        <c:ser>
          <c:idx val="9"/>
          <c:order val="9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cat>
            <c:numRef>
              <c:f>'Tumour Growth'!$Z$39:$AH$39</c:f>
              <c:numCache>
                <c:formatCode>General</c:formatCode>
                <c:ptCount val="9"/>
                <c:pt idx="0">
                  <c:v>0</c:v>
                </c:pt>
                <c:pt idx="1">
                  <c:v>9</c:v>
                </c:pt>
                <c:pt idx="2">
                  <c:v>11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  <c:pt idx="8">
                  <c:v>19</c:v>
                </c:pt>
              </c:numCache>
            </c:numRef>
          </c:cat>
          <c:val>
            <c:numRef>
              <c:f>'Tumour Growth'!$Z$59:$AE$59</c:f>
              <c:numCache>
                <c:formatCode>0.00</c:formatCode>
                <c:ptCount val="6"/>
                <c:pt idx="0" formatCode="General">
                  <c:v>0</c:v>
                </c:pt>
                <c:pt idx="1">
                  <c:v>4.1887902000000006</c:v>
                </c:pt>
                <c:pt idx="2">
                  <c:v>91.629781249999994</c:v>
                </c:pt>
                <c:pt idx="3">
                  <c:v>424.03499999999997</c:v>
                </c:pt>
                <c:pt idx="4" formatCode="General">
                  <c:v>466.43849999999998</c:v>
                </c:pt>
                <c:pt idx="5" formatCode="General">
                  <c:v>904.607999999999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4594048"/>
        <c:axId val="164595584"/>
      </c:lineChart>
      <c:dateAx>
        <c:axId val="164594048"/>
        <c:scaling>
          <c:orientation val="minMax"/>
          <c:max val="20"/>
        </c:scaling>
        <c:delete val="0"/>
        <c:axPos val="b"/>
        <c:numFmt formatCode="General" sourceLinked="1"/>
        <c:majorTickMark val="out"/>
        <c:minorTickMark val="none"/>
        <c:tickLblPos val="nextTo"/>
        <c:crossAx val="164595584"/>
        <c:crosses val="autoZero"/>
        <c:auto val="0"/>
        <c:lblOffset val="100"/>
        <c:baseTimeUnit val="days"/>
        <c:majorUnit val="2"/>
        <c:majorTimeUnit val="days"/>
      </c:dateAx>
      <c:valAx>
        <c:axId val="164595584"/>
        <c:scaling>
          <c:orientation val="minMax"/>
          <c:max val="120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9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NZ" sz="9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mour</a:t>
                </a:r>
                <a:r>
                  <a:rPr lang="en-NZ" sz="9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olume (mm</a:t>
                </a:r>
                <a:r>
                  <a:rPr lang="en-NZ" sz="900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NZ" sz="9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NZ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9512052939190161E-3"/>
              <c:y val="0.1277955271565495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45940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31663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024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1547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74218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5213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151305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09013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37906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02801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34845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34148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E25F5-71BF-438F-BAE3-12D1BDDD1812}" type="datetimeFigureOut">
              <a:rPr lang="en-NZ" smtClean="0"/>
              <a:t>3/06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1C3F3-ED7E-4ECA-983C-E70F07AB200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12001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60648" y="1979712"/>
            <a:ext cx="6377940" cy="2686621"/>
            <a:chOff x="260648" y="1979712"/>
            <a:chExt cx="6377940" cy="2686621"/>
          </a:xfrm>
        </p:grpSpPr>
        <p:grpSp>
          <p:nvGrpSpPr>
            <p:cNvPr id="4" name="Group 3"/>
            <p:cNvGrpSpPr>
              <a:grpSpLocks noChangeAspect="1"/>
            </p:cNvGrpSpPr>
            <p:nvPr/>
          </p:nvGrpSpPr>
          <p:grpSpPr>
            <a:xfrm>
              <a:off x="260648" y="2051720"/>
              <a:ext cx="6377940" cy="2614613"/>
              <a:chOff x="0" y="0"/>
              <a:chExt cx="7086600" cy="2905125"/>
            </a:xfrm>
          </p:grpSpPr>
          <p:graphicFrame>
            <p:nvGraphicFramePr>
              <p:cNvPr id="5" name="Chart 4"/>
              <p:cNvGraphicFramePr/>
              <p:nvPr>
                <p:extLst>
                  <p:ext uri="{D42A27DB-BD31-4B8C-83A1-F6EECF244321}">
                    <p14:modId xmlns:p14="http://schemas.microsoft.com/office/powerpoint/2010/main" val="1088972232"/>
                  </p:ext>
                </p:extLst>
              </p:nvPr>
            </p:nvGraphicFramePr>
            <p:xfrm>
              <a:off x="3514725" y="0"/>
              <a:ext cx="3571875" cy="29051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Chart 5"/>
              <p:cNvGraphicFramePr/>
              <p:nvPr>
                <p:extLst>
                  <p:ext uri="{D42A27DB-BD31-4B8C-83A1-F6EECF244321}">
                    <p14:modId xmlns:p14="http://schemas.microsoft.com/office/powerpoint/2010/main" val="3761020071"/>
                  </p:ext>
                </p:extLst>
              </p:nvPr>
            </p:nvGraphicFramePr>
            <p:xfrm>
              <a:off x="0" y="104775"/>
              <a:ext cx="3514725" cy="27527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7" name="TextBox 6"/>
            <p:cNvSpPr txBox="1"/>
            <p:nvPr/>
          </p:nvSpPr>
          <p:spPr>
            <a:xfrm>
              <a:off x="1556792" y="1979712"/>
              <a:ext cx="32656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400" dirty="0" smtClean="0"/>
                <a:t>B16-F10			LL/2</a:t>
              </a:r>
              <a:endParaRPr lang="en-NZ" sz="1400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88641" y="15550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Supplementary Figure 1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719338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1" y="15550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Supplementary Figure 2</a:t>
            </a:r>
            <a:endParaRPr lang="en-NZ" dirty="0"/>
          </a:p>
        </p:txBody>
      </p:sp>
      <p:grpSp>
        <p:nvGrpSpPr>
          <p:cNvPr id="12" name="Group 11"/>
          <p:cNvGrpSpPr/>
          <p:nvPr/>
        </p:nvGrpSpPr>
        <p:grpSpPr>
          <a:xfrm>
            <a:off x="188641" y="1709419"/>
            <a:ext cx="6371058" cy="5742901"/>
            <a:chOff x="188641" y="1709419"/>
            <a:chExt cx="6371058" cy="5742901"/>
          </a:xfrm>
        </p:grpSpPr>
        <p:grpSp>
          <p:nvGrpSpPr>
            <p:cNvPr id="3" name="Group 2"/>
            <p:cNvGrpSpPr/>
            <p:nvPr/>
          </p:nvGrpSpPr>
          <p:grpSpPr>
            <a:xfrm>
              <a:off x="692299" y="1937345"/>
              <a:ext cx="5867400" cy="5514975"/>
              <a:chOff x="0" y="0"/>
              <a:chExt cx="5867400" cy="5514975"/>
            </a:xfrm>
          </p:grpSpPr>
          <p:graphicFrame>
            <p:nvGraphicFramePr>
              <p:cNvPr id="5" name="Chart 4"/>
              <p:cNvGraphicFramePr/>
              <p:nvPr/>
            </p:nvGraphicFramePr>
            <p:xfrm>
              <a:off x="2895600" y="0"/>
              <a:ext cx="2971800" cy="17907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Chart 5"/>
              <p:cNvGraphicFramePr/>
              <p:nvPr/>
            </p:nvGraphicFramePr>
            <p:xfrm>
              <a:off x="2895600" y="1781175"/>
              <a:ext cx="2971800" cy="18002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7" name="Chart 6"/>
              <p:cNvGraphicFramePr/>
              <p:nvPr/>
            </p:nvGraphicFramePr>
            <p:xfrm>
              <a:off x="2895600" y="3571875"/>
              <a:ext cx="2971800" cy="19431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8" name="Chart 7"/>
              <p:cNvGraphicFramePr/>
              <p:nvPr/>
            </p:nvGraphicFramePr>
            <p:xfrm>
              <a:off x="0" y="0"/>
              <a:ext cx="2971800" cy="17811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9" name="Chart 8"/>
              <p:cNvGraphicFramePr/>
              <p:nvPr/>
            </p:nvGraphicFramePr>
            <p:xfrm>
              <a:off x="19050" y="3571875"/>
              <a:ext cx="2914650" cy="19431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0" name="Chart 9"/>
              <p:cNvGraphicFramePr/>
              <p:nvPr/>
            </p:nvGraphicFramePr>
            <p:xfrm>
              <a:off x="0" y="1781175"/>
              <a:ext cx="2933700" cy="18002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sp>
          <p:nvSpPr>
            <p:cNvPr id="4" name="Rectangle 3"/>
            <p:cNvSpPr/>
            <p:nvPr/>
          </p:nvSpPr>
          <p:spPr>
            <a:xfrm>
              <a:off x="1844824" y="1709419"/>
              <a:ext cx="3562350" cy="31432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 smtClean="0">
                  <a:solidFill>
                    <a:srgbClr val="0D0D0D"/>
                  </a:solidFill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B16-F10</a:t>
              </a:r>
              <a:r>
                <a:rPr lang="en-NZ" sz="1200" b="1" dirty="0">
                  <a:solidFill>
                    <a:srgbClr val="0D0D0D"/>
                  </a:solidFill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			LL/2</a:t>
              </a:r>
              <a:endParaRPr lang="en-NZ" sz="1100" dirty="0">
                <a:effectLst/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8641" y="1709419"/>
              <a:ext cx="793807" cy="46628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100" dirty="0" smtClean="0"/>
                <a:t>Ascorbate </a:t>
              </a:r>
            </a:p>
            <a:p>
              <a:r>
                <a:rPr lang="en-NZ" sz="1100" dirty="0" smtClean="0"/>
                <a:t>(mg/L)</a:t>
              </a:r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r>
                <a:rPr lang="en-NZ" sz="1100" dirty="0" smtClean="0"/>
                <a:t>3300</a:t>
              </a:r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r>
                <a:rPr lang="en-NZ" sz="1100" dirty="0" smtClean="0"/>
                <a:t>330</a:t>
              </a:r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 smtClean="0"/>
            </a:p>
            <a:p>
              <a:endParaRPr lang="en-NZ" sz="1100" dirty="0"/>
            </a:p>
            <a:p>
              <a:endParaRPr lang="en-NZ" sz="1100" dirty="0"/>
            </a:p>
            <a:p>
              <a:r>
                <a:rPr lang="en-NZ" sz="1100" dirty="0" smtClean="0"/>
                <a:t>33</a:t>
              </a:r>
            </a:p>
            <a:p>
              <a:endParaRPr lang="en-NZ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795061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0</Words>
  <Application>Microsoft Office PowerPoint</Application>
  <PresentationFormat>On-screen Show (4:3)</PresentationFormat>
  <Paragraphs>3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niversity of Otago, Christchu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i Dachs</dc:creator>
  <cp:lastModifiedBy>Gabi Dachs</cp:lastModifiedBy>
  <cp:revision>3</cp:revision>
  <dcterms:created xsi:type="dcterms:W3CDTF">2014-03-11T21:17:31Z</dcterms:created>
  <dcterms:modified xsi:type="dcterms:W3CDTF">2014-06-03T03:19:56Z</dcterms:modified>
</cp:coreProperties>
</file>